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45A9143-B9CC-42ED-8711-037312C1CF36}" v="2" dt="2024-07-17T10:08:05.59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78" d="100"/>
          <a:sy n="78" d="100"/>
        </p:scale>
        <p:origin x="180" y="61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Pieter De Maayer" userId="b1cb33d2-51af-4516-8002-8c8843923d78" providerId="ADAL" clId="{445A9143-B9CC-42ED-8711-037312C1CF36}"/>
    <pc:docChg chg="custSel modSld">
      <pc:chgData name="Pieter De Maayer" userId="b1cb33d2-51af-4516-8002-8c8843923d78" providerId="ADAL" clId="{445A9143-B9CC-42ED-8711-037312C1CF36}" dt="2024-07-17T10:10:01.669" v="92" actId="1037"/>
      <pc:docMkLst>
        <pc:docMk/>
      </pc:docMkLst>
      <pc:sldChg chg="addSp delSp modSp mod">
        <pc:chgData name="Pieter De Maayer" userId="b1cb33d2-51af-4516-8002-8c8843923d78" providerId="ADAL" clId="{445A9143-B9CC-42ED-8711-037312C1CF36}" dt="2024-07-17T10:06:57.828" v="62" actId="1076"/>
        <pc:sldMkLst>
          <pc:docMk/>
          <pc:sldMk cId="4179617909" sldId="256"/>
        </pc:sldMkLst>
        <pc:spChg chg="del">
          <ac:chgData name="Pieter De Maayer" userId="b1cb33d2-51af-4516-8002-8c8843923d78" providerId="ADAL" clId="{445A9143-B9CC-42ED-8711-037312C1CF36}" dt="2024-07-17T10:05:55.822" v="6" actId="478"/>
          <ac:spMkLst>
            <pc:docMk/>
            <pc:sldMk cId="4179617909" sldId="256"/>
            <ac:spMk id="2" creationId="{07248190-3009-C8D7-852C-44C1069AB54F}"/>
          </ac:spMkLst>
        </pc:spChg>
        <pc:spChg chg="add del mod">
          <ac:chgData name="Pieter De Maayer" userId="b1cb33d2-51af-4516-8002-8c8843923d78" providerId="ADAL" clId="{445A9143-B9CC-42ED-8711-037312C1CF36}" dt="2024-07-17T10:05:47.565" v="5" actId="478"/>
          <ac:spMkLst>
            <pc:docMk/>
            <pc:sldMk cId="4179617909" sldId="256"/>
            <ac:spMk id="5" creationId="{0C8A05FE-5793-7A9D-DA11-896C7C83AB2B}"/>
          </ac:spMkLst>
        </pc:spChg>
        <pc:spChg chg="add mod">
          <ac:chgData name="Pieter De Maayer" userId="b1cb33d2-51af-4516-8002-8c8843923d78" providerId="ADAL" clId="{445A9143-B9CC-42ED-8711-037312C1CF36}" dt="2024-07-17T10:06:57.828" v="62" actId="1076"/>
          <ac:spMkLst>
            <pc:docMk/>
            <pc:sldMk cId="4179617909" sldId="256"/>
            <ac:spMk id="8" creationId="{14F1D5E0-1B5A-3B96-014E-2A37F457D341}"/>
          </ac:spMkLst>
        </pc:spChg>
        <pc:graphicFrameChg chg="mod">
          <ac:chgData name="Pieter De Maayer" userId="b1cb33d2-51af-4516-8002-8c8843923d78" providerId="ADAL" clId="{445A9143-B9CC-42ED-8711-037312C1CF36}" dt="2024-07-17T10:06:53.678" v="61" actId="1036"/>
          <ac:graphicFrameMkLst>
            <pc:docMk/>
            <pc:sldMk cId="4179617909" sldId="256"/>
            <ac:graphicFrameMk id="4" creationId="{16AA65D8-B625-32FB-C40C-6964A510CC69}"/>
          </ac:graphicFrameMkLst>
        </pc:graphicFrameChg>
        <pc:picChg chg="mod">
          <ac:chgData name="Pieter De Maayer" userId="b1cb33d2-51af-4516-8002-8c8843923d78" providerId="ADAL" clId="{445A9143-B9CC-42ED-8711-037312C1CF36}" dt="2024-07-17T10:06:53.678" v="61" actId="1036"/>
          <ac:picMkLst>
            <pc:docMk/>
            <pc:sldMk cId="4179617909" sldId="256"/>
            <ac:picMk id="7" creationId="{9D0C7D3F-20D0-E547-9E60-C08C9F1E8E7F}"/>
          </ac:picMkLst>
        </pc:picChg>
      </pc:sldChg>
      <pc:sldChg chg="addSp delSp modSp mod">
        <pc:chgData name="Pieter De Maayer" userId="b1cb33d2-51af-4516-8002-8c8843923d78" providerId="ADAL" clId="{445A9143-B9CC-42ED-8711-037312C1CF36}" dt="2024-07-17T10:10:01.669" v="92" actId="1037"/>
        <pc:sldMkLst>
          <pc:docMk/>
          <pc:sldMk cId="1481650448" sldId="257"/>
        </pc:sldMkLst>
        <pc:spChg chg="del">
          <ac:chgData name="Pieter De Maayer" userId="b1cb33d2-51af-4516-8002-8c8843923d78" providerId="ADAL" clId="{445A9143-B9CC-42ED-8711-037312C1CF36}" dt="2024-07-17T10:07:03.134" v="63" actId="478"/>
          <ac:spMkLst>
            <pc:docMk/>
            <pc:sldMk cId="1481650448" sldId="257"/>
            <ac:spMk id="2" creationId="{1257D4B0-72DB-7169-9026-4BA9E02902D4}"/>
          </ac:spMkLst>
        </pc:spChg>
        <pc:spChg chg="mod">
          <ac:chgData name="Pieter De Maayer" userId="b1cb33d2-51af-4516-8002-8c8843923d78" providerId="ADAL" clId="{445A9143-B9CC-42ED-8711-037312C1CF36}" dt="2024-07-17T10:07:52.328" v="64" actId="164"/>
          <ac:spMkLst>
            <pc:docMk/>
            <pc:sldMk cId="1481650448" sldId="257"/>
            <ac:spMk id="5" creationId="{B14A0C39-F687-080F-466E-374EA93B47DE}"/>
          </ac:spMkLst>
        </pc:spChg>
        <pc:spChg chg="mod">
          <ac:chgData name="Pieter De Maayer" userId="b1cb33d2-51af-4516-8002-8c8843923d78" providerId="ADAL" clId="{445A9143-B9CC-42ED-8711-037312C1CF36}" dt="2024-07-17T10:07:52.328" v="64" actId="164"/>
          <ac:spMkLst>
            <pc:docMk/>
            <pc:sldMk cId="1481650448" sldId="257"/>
            <ac:spMk id="6" creationId="{4B0A1773-7873-FAFD-1090-277466B2F998}"/>
          </ac:spMkLst>
        </pc:spChg>
        <pc:spChg chg="mod">
          <ac:chgData name="Pieter De Maayer" userId="b1cb33d2-51af-4516-8002-8c8843923d78" providerId="ADAL" clId="{445A9143-B9CC-42ED-8711-037312C1CF36}" dt="2024-07-17T10:07:52.328" v="64" actId="164"/>
          <ac:spMkLst>
            <pc:docMk/>
            <pc:sldMk cId="1481650448" sldId="257"/>
            <ac:spMk id="8" creationId="{9488ACD9-7C79-EB37-E5DD-51F1EB8CABEA}"/>
          </ac:spMkLst>
        </pc:spChg>
        <pc:spChg chg="mod">
          <ac:chgData name="Pieter De Maayer" userId="b1cb33d2-51af-4516-8002-8c8843923d78" providerId="ADAL" clId="{445A9143-B9CC-42ED-8711-037312C1CF36}" dt="2024-07-17T10:07:52.328" v="64" actId="164"/>
          <ac:spMkLst>
            <pc:docMk/>
            <pc:sldMk cId="1481650448" sldId="257"/>
            <ac:spMk id="9" creationId="{E71666A6-5880-BAB6-D08D-728B02EDDBB0}"/>
          </ac:spMkLst>
        </pc:spChg>
        <pc:spChg chg="mod">
          <ac:chgData name="Pieter De Maayer" userId="b1cb33d2-51af-4516-8002-8c8843923d78" providerId="ADAL" clId="{445A9143-B9CC-42ED-8711-037312C1CF36}" dt="2024-07-17T10:07:52.328" v="64" actId="164"/>
          <ac:spMkLst>
            <pc:docMk/>
            <pc:sldMk cId="1481650448" sldId="257"/>
            <ac:spMk id="10" creationId="{3D8E1BFA-CCE7-11DE-1F91-D17049722C4A}"/>
          </ac:spMkLst>
        </pc:spChg>
        <pc:spChg chg="mod">
          <ac:chgData name="Pieter De Maayer" userId="b1cb33d2-51af-4516-8002-8c8843923d78" providerId="ADAL" clId="{445A9143-B9CC-42ED-8711-037312C1CF36}" dt="2024-07-17T10:07:52.328" v="64" actId="164"/>
          <ac:spMkLst>
            <pc:docMk/>
            <pc:sldMk cId="1481650448" sldId="257"/>
            <ac:spMk id="11" creationId="{4C95EA54-A72F-C600-B9A1-C74038A9AB2E}"/>
          </ac:spMkLst>
        </pc:spChg>
        <pc:spChg chg="mod">
          <ac:chgData name="Pieter De Maayer" userId="b1cb33d2-51af-4516-8002-8c8843923d78" providerId="ADAL" clId="{445A9143-B9CC-42ED-8711-037312C1CF36}" dt="2024-07-17T10:07:52.328" v="64" actId="164"/>
          <ac:spMkLst>
            <pc:docMk/>
            <pc:sldMk cId="1481650448" sldId="257"/>
            <ac:spMk id="12" creationId="{C2777FAA-37AA-1CCC-95A5-27D74A68BFB3}"/>
          </ac:spMkLst>
        </pc:spChg>
        <pc:spChg chg="mod">
          <ac:chgData name="Pieter De Maayer" userId="b1cb33d2-51af-4516-8002-8c8843923d78" providerId="ADAL" clId="{445A9143-B9CC-42ED-8711-037312C1CF36}" dt="2024-07-17T10:08:05.597" v="66" actId="164"/>
          <ac:spMkLst>
            <pc:docMk/>
            <pc:sldMk cId="1481650448" sldId="257"/>
            <ac:spMk id="15" creationId="{B9E8F151-187A-997F-ED5B-9872050A6A27}"/>
          </ac:spMkLst>
        </pc:spChg>
        <pc:spChg chg="mod">
          <ac:chgData name="Pieter De Maayer" userId="b1cb33d2-51af-4516-8002-8c8843923d78" providerId="ADAL" clId="{445A9143-B9CC-42ED-8711-037312C1CF36}" dt="2024-07-17T10:08:05.597" v="66" actId="164"/>
          <ac:spMkLst>
            <pc:docMk/>
            <pc:sldMk cId="1481650448" sldId="257"/>
            <ac:spMk id="16" creationId="{A474DE2F-078B-3D88-55C7-F17E9D910855}"/>
          </ac:spMkLst>
        </pc:spChg>
        <pc:spChg chg="mod">
          <ac:chgData name="Pieter De Maayer" userId="b1cb33d2-51af-4516-8002-8c8843923d78" providerId="ADAL" clId="{445A9143-B9CC-42ED-8711-037312C1CF36}" dt="2024-07-17T10:08:05.597" v="66" actId="164"/>
          <ac:spMkLst>
            <pc:docMk/>
            <pc:sldMk cId="1481650448" sldId="257"/>
            <ac:spMk id="17" creationId="{324B65CE-F690-278E-C482-0553FF5AFCFD}"/>
          </ac:spMkLst>
        </pc:spChg>
        <pc:spChg chg="mod">
          <ac:chgData name="Pieter De Maayer" userId="b1cb33d2-51af-4516-8002-8c8843923d78" providerId="ADAL" clId="{445A9143-B9CC-42ED-8711-037312C1CF36}" dt="2024-07-17T10:08:05.597" v="66" actId="164"/>
          <ac:spMkLst>
            <pc:docMk/>
            <pc:sldMk cId="1481650448" sldId="257"/>
            <ac:spMk id="18" creationId="{26931DEF-D5C8-F99F-2190-D4121FA9E969}"/>
          </ac:spMkLst>
        </pc:spChg>
        <pc:spChg chg="mod">
          <ac:chgData name="Pieter De Maayer" userId="b1cb33d2-51af-4516-8002-8c8843923d78" providerId="ADAL" clId="{445A9143-B9CC-42ED-8711-037312C1CF36}" dt="2024-07-17T10:08:05.597" v="66" actId="164"/>
          <ac:spMkLst>
            <pc:docMk/>
            <pc:sldMk cId="1481650448" sldId="257"/>
            <ac:spMk id="19" creationId="{4EE63227-993C-BA8E-2A14-1B0D6159E052}"/>
          </ac:spMkLst>
        </pc:spChg>
        <pc:spChg chg="mod">
          <ac:chgData name="Pieter De Maayer" userId="b1cb33d2-51af-4516-8002-8c8843923d78" providerId="ADAL" clId="{445A9143-B9CC-42ED-8711-037312C1CF36}" dt="2024-07-17T10:08:05.597" v="66" actId="164"/>
          <ac:spMkLst>
            <pc:docMk/>
            <pc:sldMk cId="1481650448" sldId="257"/>
            <ac:spMk id="20" creationId="{35FBCAEE-CBD9-828D-C19C-F29F07FE8826}"/>
          </ac:spMkLst>
        </pc:spChg>
        <pc:spChg chg="mod">
          <ac:chgData name="Pieter De Maayer" userId="b1cb33d2-51af-4516-8002-8c8843923d78" providerId="ADAL" clId="{445A9143-B9CC-42ED-8711-037312C1CF36}" dt="2024-07-17T10:08:05.597" v="66" actId="164"/>
          <ac:spMkLst>
            <pc:docMk/>
            <pc:sldMk cId="1481650448" sldId="257"/>
            <ac:spMk id="21" creationId="{22D57FB0-CB33-F575-8E6D-9EB61B5E2B9C}"/>
          </ac:spMkLst>
        </pc:spChg>
        <pc:spChg chg="mod">
          <ac:chgData name="Pieter De Maayer" userId="b1cb33d2-51af-4516-8002-8c8843923d78" providerId="ADAL" clId="{445A9143-B9CC-42ED-8711-037312C1CF36}" dt="2024-07-17T10:09:03.717" v="74" actId="1076"/>
          <ac:spMkLst>
            <pc:docMk/>
            <pc:sldMk cId="1481650448" sldId="257"/>
            <ac:spMk id="22" creationId="{7D0374B6-47CA-0405-37CE-4CE22DB02A84}"/>
          </ac:spMkLst>
        </pc:spChg>
        <pc:spChg chg="mod">
          <ac:chgData name="Pieter De Maayer" userId="b1cb33d2-51af-4516-8002-8c8843923d78" providerId="ADAL" clId="{445A9143-B9CC-42ED-8711-037312C1CF36}" dt="2024-07-17T10:09:03.717" v="74" actId="1076"/>
          <ac:spMkLst>
            <pc:docMk/>
            <pc:sldMk cId="1481650448" sldId="257"/>
            <ac:spMk id="23" creationId="{F7AC78BA-F4D2-60BF-6970-97DC04731EF4}"/>
          </ac:spMkLst>
        </pc:spChg>
        <pc:spChg chg="mod">
          <ac:chgData name="Pieter De Maayer" userId="b1cb33d2-51af-4516-8002-8c8843923d78" providerId="ADAL" clId="{445A9143-B9CC-42ED-8711-037312C1CF36}" dt="2024-07-17T10:09:03.717" v="74" actId="1076"/>
          <ac:spMkLst>
            <pc:docMk/>
            <pc:sldMk cId="1481650448" sldId="257"/>
            <ac:spMk id="24" creationId="{3B665AF2-7D63-C32A-B8F6-16DF191E9B78}"/>
          </ac:spMkLst>
        </pc:spChg>
        <pc:spChg chg="mod">
          <ac:chgData name="Pieter De Maayer" userId="b1cb33d2-51af-4516-8002-8c8843923d78" providerId="ADAL" clId="{445A9143-B9CC-42ED-8711-037312C1CF36}" dt="2024-07-17T10:09:03.717" v="74" actId="1076"/>
          <ac:spMkLst>
            <pc:docMk/>
            <pc:sldMk cId="1481650448" sldId="257"/>
            <ac:spMk id="25" creationId="{415A3DF1-B0BC-A917-C20B-5A08C0E10FE7}"/>
          </ac:spMkLst>
        </pc:spChg>
        <pc:spChg chg="mod">
          <ac:chgData name="Pieter De Maayer" userId="b1cb33d2-51af-4516-8002-8c8843923d78" providerId="ADAL" clId="{445A9143-B9CC-42ED-8711-037312C1CF36}" dt="2024-07-17T10:09:03.717" v="74" actId="1076"/>
          <ac:spMkLst>
            <pc:docMk/>
            <pc:sldMk cId="1481650448" sldId="257"/>
            <ac:spMk id="26" creationId="{EF7E7C76-E1BE-A6CF-A8BA-520A726B2178}"/>
          </ac:spMkLst>
        </pc:spChg>
        <pc:spChg chg="mod">
          <ac:chgData name="Pieter De Maayer" userId="b1cb33d2-51af-4516-8002-8c8843923d78" providerId="ADAL" clId="{445A9143-B9CC-42ED-8711-037312C1CF36}" dt="2024-07-17T10:09:03.717" v="74" actId="1076"/>
          <ac:spMkLst>
            <pc:docMk/>
            <pc:sldMk cId="1481650448" sldId="257"/>
            <ac:spMk id="27" creationId="{0B1FD582-C1AE-575B-15C9-3B4B0131F283}"/>
          </ac:spMkLst>
        </pc:spChg>
        <pc:spChg chg="mod ord">
          <ac:chgData name="Pieter De Maayer" userId="b1cb33d2-51af-4516-8002-8c8843923d78" providerId="ADAL" clId="{445A9143-B9CC-42ED-8711-037312C1CF36}" dt="2024-07-17T10:09:03.717" v="74" actId="1076"/>
          <ac:spMkLst>
            <pc:docMk/>
            <pc:sldMk cId="1481650448" sldId="257"/>
            <ac:spMk id="28" creationId="{32CA27F4-C171-B408-88AA-E14D34E087BA}"/>
          </ac:spMkLst>
        </pc:spChg>
        <pc:spChg chg="mod">
          <ac:chgData name="Pieter De Maayer" userId="b1cb33d2-51af-4516-8002-8c8843923d78" providerId="ADAL" clId="{445A9143-B9CC-42ED-8711-037312C1CF36}" dt="2024-07-17T10:07:52.328" v="64" actId="164"/>
          <ac:spMkLst>
            <pc:docMk/>
            <pc:sldMk cId="1481650448" sldId="257"/>
            <ac:spMk id="29" creationId="{CB5FBEB5-3AFB-AE52-3521-863FAB3948EA}"/>
          </ac:spMkLst>
        </pc:spChg>
        <pc:spChg chg="mod">
          <ac:chgData name="Pieter De Maayer" userId="b1cb33d2-51af-4516-8002-8c8843923d78" providerId="ADAL" clId="{445A9143-B9CC-42ED-8711-037312C1CF36}" dt="2024-07-17T10:08:05.597" v="66" actId="164"/>
          <ac:spMkLst>
            <pc:docMk/>
            <pc:sldMk cId="1481650448" sldId="257"/>
            <ac:spMk id="30" creationId="{8453CDFD-9EC2-8CA7-E731-0456BB9BEBAC}"/>
          </ac:spMkLst>
        </pc:spChg>
        <pc:spChg chg="mod">
          <ac:chgData name="Pieter De Maayer" userId="b1cb33d2-51af-4516-8002-8c8843923d78" providerId="ADAL" clId="{445A9143-B9CC-42ED-8711-037312C1CF36}" dt="2024-07-17T10:08:36.387" v="71" actId="1076"/>
          <ac:spMkLst>
            <pc:docMk/>
            <pc:sldMk cId="1481650448" sldId="257"/>
            <ac:spMk id="31" creationId="{2ED41CDB-E546-94F4-AD00-6EFB86A3B631}"/>
          </ac:spMkLst>
        </pc:spChg>
        <pc:spChg chg="add mod">
          <ac:chgData name="Pieter De Maayer" userId="b1cb33d2-51af-4516-8002-8c8843923d78" providerId="ADAL" clId="{445A9143-B9CC-42ED-8711-037312C1CF36}" dt="2024-07-17T10:10:01.669" v="92" actId="1037"/>
          <ac:spMkLst>
            <pc:docMk/>
            <pc:sldMk cId="1481650448" sldId="257"/>
            <ac:spMk id="33" creationId="{FFAAC9B4-4C84-49FB-A0F3-43D8CB6F2284}"/>
          </ac:spMkLst>
        </pc:spChg>
        <pc:grpChg chg="add mod">
          <ac:chgData name="Pieter De Maayer" userId="b1cb33d2-51af-4516-8002-8c8843923d78" providerId="ADAL" clId="{445A9143-B9CC-42ED-8711-037312C1CF36}" dt="2024-07-17T10:07:55.205" v="65" actId="1076"/>
          <ac:grpSpMkLst>
            <pc:docMk/>
            <pc:sldMk cId="1481650448" sldId="257"/>
            <ac:grpSpMk id="4" creationId="{A5926870-E766-4165-2D17-07A146DA36EE}"/>
          </ac:grpSpMkLst>
        </pc:grpChg>
        <pc:grpChg chg="add mod ord">
          <ac:chgData name="Pieter De Maayer" userId="b1cb33d2-51af-4516-8002-8c8843923d78" providerId="ADAL" clId="{445A9143-B9CC-42ED-8711-037312C1CF36}" dt="2024-07-17T10:09:15.069" v="76" actId="14100"/>
          <ac:grpSpMkLst>
            <pc:docMk/>
            <pc:sldMk cId="1481650448" sldId="257"/>
            <ac:grpSpMk id="7" creationId="{96AF5453-FBCB-4A11-1715-91A5625DE822}"/>
          </ac:grpSpMkLst>
        </pc:grpChg>
        <pc:graphicFrameChg chg="mod">
          <ac:chgData name="Pieter De Maayer" userId="b1cb33d2-51af-4516-8002-8c8843923d78" providerId="ADAL" clId="{445A9143-B9CC-42ED-8711-037312C1CF36}" dt="2024-07-17T10:07:52.328" v="64" actId="164"/>
          <ac:graphicFrameMkLst>
            <pc:docMk/>
            <pc:sldMk cId="1481650448" sldId="257"/>
            <ac:graphicFrameMk id="3" creationId="{42A7F08F-3199-C3D3-04BB-D94F183DCCF2}"/>
          </ac:graphicFrameMkLst>
        </pc:graphicFrameChg>
        <pc:graphicFrameChg chg="mod">
          <ac:chgData name="Pieter De Maayer" userId="b1cb33d2-51af-4516-8002-8c8843923d78" providerId="ADAL" clId="{445A9143-B9CC-42ED-8711-037312C1CF36}" dt="2024-07-17T10:08:05.597" v="66" actId="164"/>
          <ac:graphicFrameMkLst>
            <pc:docMk/>
            <pc:sldMk cId="1481650448" sldId="257"/>
            <ac:graphicFrameMk id="13" creationId="{E50F3628-2D0B-BB78-4282-E315909CEF7D}"/>
          </ac:graphicFrameMkLst>
        </pc:graphicFrameChg>
        <pc:graphicFrameChg chg="mod">
          <ac:chgData name="Pieter De Maayer" userId="b1cb33d2-51af-4516-8002-8c8843923d78" providerId="ADAL" clId="{445A9143-B9CC-42ED-8711-037312C1CF36}" dt="2024-07-17T10:08:41.276" v="72" actId="1076"/>
          <ac:graphicFrameMkLst>
            <pc:docMk/>
            <pc:sldMk cId="1481650448" sldId="257"/>
            <ac:graphicFrameMk id="14" creationId="{7A7B3697-DEEE-A8B6-BADC-BF290926C11B}"/>
          </ac:graphicFrameMkLst>
        </pc:graphicFrameChg>
      </pc:sldChg>
    </pc:docChg>
  </pc:docChgLst>
  <pc:docChgLst>
    <pc:chgData name="Pieter De Maayer" userId="b1cb33d2-51af-4516-8002-8c8843923d78" providerId="ADAL" clId="{A7D5FC1E-1219-4304-9245-17763D33E6A3}"/>
    <pc:docChg chg="custSel modSld">
      <pc:chgData name="Pieter De Maayer" userId="b1cb33d2-51af-4516-8002-8c8843923d78" providerId="ADAL" clId="{A7D5FC1E-1219-4304-9245-17763D33E6A3}" dt="2024-02-20T05:59:46.540" v="1"/>
      <pc:docMkLst>
        <pc:docMk/>
      </pc:docMkLst>
      <pc:sldChg chg="addSp delSp modSp mod">
        <pc:chgData name="Pieter De Maayer" userId="b1cb33d2-51af-4516-8002-8c8843923d78" providerId="ADAL" clId="{A7D5FC1E-1219-4304-9245-17763D33E6A3}" dt="2024-02-20T05:59:46.540" v="1"/>
        <pc:sldMkLst>
          <pc:docMk/>
          <pc:sldMk cId="1481650448" sldId="257"/>
        </pc:sldMkLst>
        <pc:spChg chg="add mod">
          <ac:chgData name="Pieter De Maayer" userId="b1cb33d2-51af-4516-8002-8c8843923d78" providerId="ADAL" clId="{A7D5FC1E-1219-4304-9245-17763D33E6A3}" dt="2024-02-20T05:59:46.540" v="1"/>
          <ac:spMkLst>
            <pc:docMk/>
            <pc:sldMk cId="1481650448" sldId="257"/>
            <ac:spMk id="5" creationId="{B14A0C39-F687-080F-466E-374EA93B47DE}"/>
          </ac:spMkLst>
        </pc:spChg>
        <pc:spChg chg="add mod">
          <ac:chgData name="Pieter De Maayer" userId="b1cb33d2-51af-4516-8002-8c8843923d78" providerId="ADAL" clId="{A7D5FC1E-1219-4304-9245-17763D33E6A3}" dt="2024-02-20T05:59:46.540" v="1"/>
          <ac:spMkLst>
            <pc:docMk/>
            <pc:sldMk cId="1481650448" sldId="257"/>
            <ac:spMk id="6" creationId="{4B0A1773-7873-FAFD-1090-277466B2F998}"/>
          </ac:spMkLst>
        </pc:spChg>
        <pc:spChg chg="add mod">
          <ac:chgData name="Pieter De Maayer" userId="b1cb33d2-51af-4516-8002-8c8843923d78" providerId="ADAL" clId="{A7D5FC1E-1219-4304-9245-17763D33E6A3}" dt="2024-02-20T05:59:46.540" v="1"/>
          <ac:spMkLst>
            <pc:docMk/>
            <pc:sldMk cId="1481650448" sldId="257"/>
            <ac:spMk id="8" creationId="{9488ACD9-7C79-EB37-E5DD-51F1EB8CABEA}"/>
          </ac:spMkLst>
        </pc:spChg>
        <pc:spChg chg="add mod">
          <ac:chgData name="Pieter De Maayer" userId="b1cb33d2-51af-4516-8002-8c8843923d78" providerId="ADAL" clId="{A7D5FC1E-1219-4304-9245-17763D33E6A3}" dt="2024-02-20T05:59:46.540" v="1"/>
          <ac:spMkLst>
            <pc:docMk/>
            <pc:sldMk cId="1481650448" sldId="257"/>
            <ac:spMk id="9" creationId="{E71666A6-5880-BAB6-D08D-728B02EDDBB0}"/>
          </ac:spMkLst>
        </pc:spChg>
        <pc:spChg chg="add mod">
          <ac:chgData name="Pieter De Maayer" userId="b1cb33d2-51af-4516-8002-8c8843923d78" providerId="ADAL" clId="{A7D5FC1E-1219-4304-9245-17763D33E6A3}" dt="2024-02-20T05:59:46.540" v="1"/>
          <ac:spMkLst>
            <pc:docMk/>
            <pc:sldMk cId="1481650448" sldId="257"/>
            <ac:spMk id="10" creationId="{3D8E1BFA-CCE7-11DE-1F91-D17049722C4A}"/>
          </ac:spMkLst>
        </pc:spChg>
        <pc:spChg chg="add mod">
          <ac:chgData name="Pieter De Maayer" userId="b1cb33d2-51af-4516-8002-8c8843923d78" providerId="ADAL" clId="{A7D5FC1E-1219-4304-9245-17763D33E6A3}" dt="2024-02-20T05:59:46.540" v="1"/>
          <ac:spMkLst>
            <pc:docMk/>
            <pc:sldMk cId="1481650448" sldId="257"/>
            <ac:spMk id="11" creationId="{4C95EA54-A72F-C600-B9A1-C74038A9AB2E}"/>
          </ac:spMkLst>
        </pc:spChg>
        <pc:spChg chg="add mod">
          <ac:chgData name="Pieter De Maayer" userId="b1cb33d2-51af-4516-8002-8c8843923d78" providerId="ADAL" clId="{A7D5FC1E-1219-4304-9245-17763D33E6A3}" dt="2024-02-20T05:59:46.540" v="1"/>
          <ac:spMkLst>
            <pc:docMk/>
            <pc:sldMk cId="1481650448" sldId="257"/>
            <ac:spMk id="12" creationId="{C2777FAA-37AA-1CCC-95A5-27D74A68BFB3}"/>
          </ac:spMkLst>
        </pc:spChg>
        <pc:spChg chg="add mod">
          <ac:chgData name="Pieter De Maayer" userId="b1cb33d2-51af-4516-8002-8c8843923d78" providerId="ADAL" clId="{A7D5FC1E-1219-4304-9245-17763D33E6A3}" dt="2024-02-20T05:59:46.540" v="1"/>
          <ac:spMkLst>
            <pc:docMk/>
            <pc:sldMk cId="1481650448" sldId="257"/>
            <ac:spMk id="15" creationId="{B9E8F151-187A-997F-ED5B-9872050A6A27}"/>
          </ac:spMkLst>
        </pc:spChg>
        <pc:spChg chg="add mod">
          <ac:chgData name="Pieter De Maayer" userId="b1cb33d2-51af-4516-8002-8c8843923d78" providerId="ADAL" clId="{A7D5FC1E-1219-4304-9245-17763D33E6A3}" dt="2024-02-20T05:59:46.540" v="1"/>
          <ac:spMkLst>
            <pc:docMk/>
            <pc:sldMk cId="1481650448" sldId="257"/>
            <ac:spMk id="16" creationId="{A474DE2F-078B-3D88-55C7-F17E9D910855}"/>
          </ac:spMkLst>
        </pc:spChg>
        <pc:spChg chg="add mod">
          <ac:chgData name="Pieter De Maayer" userId="b1cb33d2-51af-4516-8002-8c8843923d78" providerId="ADAL" clId="{A7D5FC1E-1219-4304-9245-17763D33E6A3}" dt="2024-02-20T05:59:46.540" v="1"/>
          <ac:spMkLst>
            <pc:docMk/>
            <pc:sldMk cId="1481650448" sldId="257"/>
            <ac:spMk id="17" creationId="{324B65CE-F690-278E-C482-0553FF5AFCFD}"/>
          </ac:spMkLst>
        </pc:spChg>
        <pc:spChg chg="add mod">
          <ac:chgData name="Pieter De Maayer" userId="b1cb33d2-51af-4516-8002-8c8843923d78" providerId="ADAL" clId="{A7D5FC1E-1219-4304-9245-17763D33E6A3}" dt="2024-02-20T05:59:46.540" v="1"/>
          <ac:spMkLst>
            <pc:docMk/>
            <pc:sldMk cId="1481650448" sldId="257"/>
            <ac:spMk id="18" creationId="{26931DEF-D5C8-F99F-2190-D4121FA9E969}"/>
          </ac:spMkLst>
        </pc:spChg>
        <pc:spChg chg="add mod">
          <ac:chgData name="Pieter De Maayer" userId="b1cb33d2-51af-4516-8002-8c8843923d78" providerId="ADAL" clId="{A7D5FC1E-1219-4304-9245-17763D33E6A3}" dt="2024-02-20T05:59:46.540" v="1"/>
          <ac:spMkLst>
            <pc:docMk/>
            <pc:sldMk cId="1481650448" sldId="257"/>
            <ac:spMk id="19" creationId="{4EE63227-993C-BA8E-2A14-1B0D6159E052}"/>
          </ac:spMkLst>
        </pc:spChg>
        <pc:spChg chg="add mod">
          <ac:chgData name="Pieter De Maayer" userId="b1cb33d2-51af-4516-8002-8c8843923d78" providerId="ADAL" clId="{A7D5FC1E-1219-4304-9245-17763D33E6A3}" dt="2024-02-20T05:59:46.540" v="1"/>
          <ac:spMkLst>
            <pc:docMk/>
            <pc:sldMk cId="1481650448" sldId="257"/>
            <ac:spMk id="20" creationId="{35FBCAEE-CBD9-828D-C19C-F29F07FE8826}"/>
          </ac:spMkLst>
        </pc:spChg>
        <pc:spChg chg="add mod">
          <ac:chgData name="Pieter De Maayer" userId="b1cb33d2-51af-4516-8002-8c8843923d78" providerId="ADAL" clId="{A7D5FC1E-1219-4304-9245-17763D33E6A3}" dt="2024-02-20T05:59:46.540" v="1"/>
          <ac:spMkLst>
            <pc:docMk/>
            <pc:sldMk cId="1481650448" sldId="257"/>
            <ac:spMk id="21" creationId="{22D57FB0-CB33-F575-8E6D-9EB61B5E2B9C}"/>
          </ac:spMkLst>
        </pc:spChg>
        <pc:spChg chg="add mod">
          <ac:chgData name="Pieter De Maayer" userId="b1cb33d2-51af-4516-8002-8c8843923d78" providerId="ADAL" clId="{A7D5FC1E-1219-4304-9245-17763D33E6A3}" dt="2024-02-20T05:59:46.540" v="1"/>
          <ac:spMkLst>
            <pc:docMk/>
            <pc:sldMk cId="1481650448" sldId="257"/>
            <ac:spMk id="22" creationId="{7D0374B6-47CA-0405-37CE-4CE22DB02A84}"/>
          </ac:spMkLst>
        </pc:spChg>
        <pc:spChg chg="add mod">
          <ac:chgData name="Pieter De Maayer" userId="b1cb33d2-51af-4516-8002-8c8843923d78" providerId="ADAL" clId="{A7D5FC1E-1219-4304-9245-17763D33E6A3}" dt="2024-02-20T05:59:46.540" v="1"/>
          <ac:spMkLst>
            <pc:docMk/>
            <pc:sldMk cId="1481650448" sldId="257"/>
            <ac:spMk id="23" creationId="{F7AC78BA-F4D2-60BF-6970-97DC04731EF4}"/>
          </ac:spMkLst>
        </pc:spChg>
        <pc:spChg chg="add mod">
          <ac:chgData name="Pieter De Maayer" userId="b1cb33d2-51af-4516-8002-8c8843923d78" providerId="ADAL" clId="{A7D5FC1E-1219-4304-9245-17763D33E6A3}" dt="2024-02-20T05:59:46.540" v="1"/>
          <ac:spMkLst>
            <pc:docMk/>
            <pc:sldMk cId="1481650448" sldId="257"/>
            <ac:spMk id="24" creationId="{3B665AF2-7D63-C32A-B8F6-16DF191E9B78}"/>
          </ac:spMkLst>
        </pc:spChg>
        <pc:spChg chg="add mod">
          <ac:chgData name="Pieter De Maayer" userId="b1cb33d2-51af-4516-8002-8c8843923d78" providerId="ADAL" clId="{A7D5FC1E-1219-4304-9245-17763D33E6A3}" dt="2024-02-20T05:59:46.540" v="1"/>
          <ac:spMkLst>
            <pc:docMk/>
            <pc:sldMk cId="1481650448" sldId="257"/>
            <ac:spMk id="25" creationId="{415A3DF1-B0BC-A917-C20B-5A08C0E10FE7}"/>
          </ac:spMkLst>
        </pc:spChg>
        <pc:spChg chg="add mod">
          <ac:chgData name="Pieter De Maayer" userId="b1cb33d2-51af-4516-8002-8c8843923d78" providerId="ADAL" clId="{A7D5FC1E-1219-4304-9245-17763D33E6A3}" dt="2024-02-20T05:59:46.540" v="1"/>
          <ac:spMkLst>
            <pc:docMk/>
            <pc:sldMk cId="1481650448" sldId="257"/>
            <ac:spMk id="26" creationId="{EF7E7C76-E1BE-A6CF-A8BA-520A726B2178}"/>
          </ac:spMkLst>
        </pc:spChg>
        <pc:spChg chg="add mod">
          <ac:chgData name="Pieter De Maayer" userId="b1cb33d2-51af-4516-8002-8c8843923d78" providerId="ADAL" clId="{A7D5FC1E-1219-4304-9245-17763D33E6A3}" dt="2024-02-20T05:59:46.540" v="1"/>
          <ac:spMkLst>
            <pc:docMk/>
            <pc:sldMk cId="1481650448" sldId="257"/>
            <ac:spMk id="27" creationId="{0B1FD582-C1AE-575B-15C9-3B4B0131F283}"/>
          </ac:spMkLst>
        </pc:spChg>
        <pc:spChg chg="add mod">
          <ac:chgData name="Pieter De Maayer" userId="b1cb33d2-51af-4516-8002-8c8843923d78" providerId="ADAL" clId="{A7D5FC1E-1219-4304-9245-17763D33E6A3}" dt="2024-02-20T05:59:46.540" v="1"/>
          <ac:spMkLst>
            <pc:docMk/>
            <pc:sldMk cId="1481650448" sldId="257"/>
            <ac:spMk id="28" creationId="{32CA27F4-C171-B408-88AA-E14D34E087BA}"/>
          </ac:spMkLst>
        </pc:spChg>
        <pc:spChg chg="add mod">
          <ac:chgData name="Pieter De Maayer" userId="b1cb33d2-51af-4516-8002-8c8843923d78" providerId="ADAL" clId="{A7D5FC1E-1219-4304-9245-17763D33E6A3}" dt="2024-02-20T05:59:46.540" v="1"/>
          <ac:spMkLst>
            <pc:docMk/>
            <pc:sldMk cId="1481650448" sldId="257"/>
            <ac:spMk id="29" creationId="{CB5FBEB5-3AFB-AE52-3521-863FAB3948EA}"/>
          </ac:spMkLst>
        </pc:spChg>
        <pc:spChg chg="add mod">
          <ac:chgData name="Pieter De Maayer" userId="b1cb33d2-51af-4516-8002-8c8843923d78" providerId="ADAL" clId="{A7D5FC1E-1219-4304-9245-17763D33E6A3}" dt="2024-02-20T05:59:46.540" v="1"/>
          <ac:spMkLst>
            <pc:docMk/>
            <pc:sldMk cId="1481650448" sldId="257"/>
            <ac:spMk id="30" creationId="{8453CDFD-9EC2-8CA7-E731-0456BB9BEBAC}"/>
          </ac:spMkLst>
        </pc:spChg>
        <pc:spChg chg="add mod">
          <ac:chgData name="Pieter De Maayer" userId="b1cb33d2-51af-4516-8002-8c8843923d78" providerId="ADAL" clId="{A7D5FC1E-1219-4304-9245-17763D33E6A3}" dt="2024-02-20T05:59:46.540" v="1"/>
          <ac:spMkLst>
            <pc:docMk/>
            <pc:sldMk cId="1481650448" sldId="257"/>
            <ac:spMk id="31" creationId="{2ED41CDB-E546-94F4-AD00-6EFB86A3B631}"/>
          </ac:spMkLst>
        </pc:spChg>
        <pc:graphicFrameChg chg="add mod">
          <ac:chgData name="Pieter De Maayer" userId="b1cb33d2-51af-4516-8002-8c8843923d78" providerId="ADAL" clId="{A7D5FC1E-1219-4304-9245-17763D33E6A3}" dt="2024-02-20T05:59:46.540" v="1"/>
          <ac:graphicFrameMkLst>
            <pc:docMk/>
            <pc:sldMk cId="1481650448" sldId="257"/>
            <ac:graphicFrameMk id="3" creationId="{42A7F08F-3199-C3D3-04BB-D94F183DCCF2}"/>
          </ac:graphicFrameMkLst>
        </pc:graphicFrameChg>
        <pc:graphicFrameChg chg="del">
          <ac:chgData name="Pieter De Maayer" userId="b1cb33d2-51af-4516-8002-8c8843923d78" providerId="ADAL" clId="{A7D5FC1E-1219-4304-9245-17763D33E6A3}" dt="2024-02-20T05:59:45.755" v="0" actId="478"/>
          <ac:graphicFrameMkLst>
            <pc:docMk/>
            <pc:sldMk cId="1481650448" sldId="257"/>
            <ac:graphicFrameMk id="4" creationId="{E2DC224E-BE55-6D04-AFB4-3BF08354A94B}"/>
          </ac:graphicFrameMkLst>
        </pc:graphicFrameChg>
        <pc:graphicFrameChg chg="add mod">
          <ac:chgData name="Pieter De Maayer" userId="b1cb33d2-51af-4516-8002-8c8843923d78" providerId="ADAL" clId="{A7D5FC1E-1219-4304-9245-17763D33E6A3}" dt="2024-02-20T05:59:46.540" v="1"/>
          <ac:graphicFrameMkLst>
            <pc:docMk/>
            <pc:sldMk cId="1481650448" sldId="257"/>
            <ac:graphicFrameMk id="13" creationId="{E50F3628-2D0B-BB78-4282-E315909CEF7D}"/>
          </ac:graphicFrameMkLst>
        </pc:graphicFrameChg>
        <pc:graphicFrameChg chg="add mod">
          <ac:chgData name="Pieter De Maayer" userId="b1cb33d2-51af-4516-8002-8c8843923d78" providerId="ADAL" clId="{A7D5FC1E-1219-4304-9245-17763D33E6A3}" dt="2024-02-20T05:59:46.540" v="1"/>
          <ac:graphicFrameMkLst>
            <pc:docMk/>
            <pc:sldMk cId="1481650448" sldId="257"/>
            <ac:graphicFrameMk id="14" creationId="{7A7B3697-DEEE-A8B6-BADC-BF290926C11B}"/>
          </ac:graphicFrameMkLst>
        </pc:graphicFrameChg>
        <pc:picChg chg="del">
          <ac:chgData name="Pieter De Maayer" userId="b1cb33d2-51af-4516-8002-8c8843923d78" providerId="ADAL" clId="{A7D5FC1E-1219-4304-9245-17763D33E6A3}" dt="2024-02-20T05:59:45.755" v="0" actId="478"/>
          <ac:picMkLst>
            <pc:docMk/>
            <pc:sldMk cId="1481650448" sldId="257"/>
            <ac:picMk id="7" creationId="{F706F15C-9A8C-ADAF-D8A5-844CADE3BCF7}"/>
          </ac:picMkLst>
        </pc:pic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witscloud-my.sharepoint.com/personal/a0050451_wits_ac_za/Documents/Parageo+Saccharo_pan-genome/Michael_stuff/Parageobacillus%20saccharococcus%20pan%20genome/Master%20sheet.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Book4"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Book4"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5030621172353453E-2"/>
          <c:y val="2.5428331875182269E-2"/>
          <c:w val="0.91558462217016257"/>
          <c:h val="0.73577136191309422"/>
        </c:manualLayout>
      </c:layout>
      <c:barChart>
        <c:barDir val="col"/>
        <c:grouping val="stacked"/>
        <c:varyColors val="0"/>
        <c:ser>
          <c:idx val="3"/>
          <c:order val="0"/>
          <c:tx>
            <c:strRef>
              <c:f>'[Master sheet.xlsx]Sheet8'!$Y$6</c:f>
              <c:strCache>
                <c:ptCount val="1"/>
                <c:pt idx="0">
                  <c:v>Poorly characterized</c:v>
                </c:pt>
              </c:strCache>
            </c:strRef>
          </c:tx>
          <c:spPr>
            <a:solidFill>
              <a:schemeClr val="accent4"/>
            </a:solidFill>
            <a:ln>
              <a:noFill/>
            </a:ln>
            <a:effectLst/>
          </c:spPr>
          <c:invertIfNegative val="0"/>
          <c:cat>
            <c:strRef>
              <c:f>'[Master sheet.xlsx]Sheet8'!$U$7:$U$9</c:f>
              <c:strCache>
                <c:ptCount val="3"/>
                <c:pt idx="0">
                  <c:v>Parageobacillus (24)</c:v>
                </c:pt>
                <c:pt idx="1">
                  <c:v>Saccharococcus (11)</c:v>
                </c:pt>
                <c:pt idx="2">
                  <c:v>Geobacillus (1)</c:v>
                </c:pt>
              </c:strCache>
            </c:strRef>
          </c:cat>
          <c:val>
            <c:numRef>
              <c:f>'[Master sheet.xlsx]Sheet8'!$Y$7:$Y$9</c:f>
              <c:numCache>
                <c:formatCode>0.00</c:formatCode>
                <c:ptCount val="3"/>
                <c:pt idx="0">
                  <c:v>31.4136400452517</c:v>
                </c:pt>
                <c:pt idx="1">
                  <c:v>31.30681421361443</c:v>
                </c:pt>
                <c:pt idx="2">
                  <c:v>34.604018912529547</c:v>
                </c:pt>
              </c:numCache>
            </c:numRef>
          </c:val>
          <c:extLst>
            <c:ext xmlns:c16="http://schemas.microsoft.com/office/drawing/2014/chart" uri="{C3380CC4-5D6E-409C-BE32-E72D297353CC}">
              <c16:uniqueId val="{00000000-8886-47A1-911D-1EF5680B5D3A}"/>
            </c:ext>
          </c:extLst>
        </c:ser>
        <c:ser>
          <c:idx val="2"/>
          <c:order val="1"/>
          <c:tx>
            <c:strRef>
              <c:f>'[Master sheet.xlsx]Sheet8'!$X$6</c:f>
              <c:strCache>
                <c:ptCount val="1"/>
                <c:pt idx="0">
                  <c:v>Metabolism</c:v>
                </c:pt>
              </c:strCache>
            </c:strRef>
          </c:tx>
          <c:spPr>
            <a:solidFill>
              <a:schemeClr val="accent3"/>
            </a:solidFill>
            <a:ln>
              <a:noFill/>
            </a:ln>
            <a:effectLst/>
          </c:spPr>
          <c:invertIfNegative val="0"/>
          <c:cat>
            <c:strRef>
              <c:f>'[Master sheet.xlsx]Sheet8'!$U$7:$U$9</c:f>
              <c:strCache>
                <c:ptCount val="3"/>
                <c:pt idx="0">
                  <c:v>Parageobacillus (24)</c:v>
                </c:pt>
                <c:pt idx="1">
                  <c:v>Saccharococcus (11)</c:v>
                </c:pt>
                <c:pt idx="2">
                  <c:v>Geobacillus (1)</c:v>
                </c:pt>
              </c:strCache>
            </c:strRef>
          </c:cat>
          <c:val>
            <c:numRef>
              <c:f>'[Master sheet.xlsx]Sheet8'!$X$7:$X$9</c:f>
              <c:numCache>
                <c:formatCode>0.00</c:formatCode>
                <c:ptCount val="3"/>
                <c:pt idx="0">
                  <c:v>35.258379591553975</c:v>
                </c:pt>
                <c:pt idx="1">
                  <c:v>37.210598959569616</c:v>
                </c:pt>
                <c:pt idx="2">
                  <c:v>35.815602836879435</c:v>
                </c:pt>
              </c:numCache>
            </c:numRef>
          </c:val>
          <c:extLst>
            <c:ext xmlns:c16="http://schemas.microsoft.com/office/drawing/2014/chart" uri="{C3380CC4-5D6E-409C-BE32-E72D297353CC}">
              <c16:uniqueId val="{00000001-8886-47A1-911D-1EF5680B5D3A}"/>
            </c:ext>
          </c:extLst>
        </c:ser>
        <c:ser>
          <c:idx val="0"/>
          <c:order val="2"/>
          <c:tx>
            <c:strRef>
              <c:f>'[Master sheet.xlsx]Sheet8'!$V$6</c:f>
              <c:strCache>
                <c:ptCount val="1"/>
                <c:pt idx="0">
                  <c:v>Information processing &amp; storage</c:v>
                </c:pt>
              </c:strCache>
            </c:strRef>
          </c:tx>
          <c:spPr>
            <a:solidFill>
              <a:schemeClr val="accent1"/>
            </a:solidFill>
            <a:ln>
              <a:noFill/>
            </a:ln>
            <a:effectLst/>
          </c:spPr>
          <c:invertIfNegative val="0"/>
          <c:cat>
            <c:strRef>
              <c:f>'[Master sheet.xlsx]Sheet8'!$U$7:$U$9</c:f>
              <c:strCache>
                <c:ptCount val="3"/>
                <c:pt idx="0">
                  <c:v>Parageobacillus (24)</c:v>
                </c:pt>
                <c:pt idx="1">
                  <c:v>Saccharococcus (11)</c:v>
                </c:pt>
                <c:pt idx="2">
                  <c:v>Geobacillus (1)</c:v>
                </c:pt>
              </c:strCache>
            </c:strRef>
          </c:cat>
          <c:val>
            <c:numRef>
              <c:f>'[Master sheet.xlsx]Sheet8'!$V$7:$V$9</c:f>
              <c:numCache>
                <c:formatCode>0.00</c:formatCode>
                <c:ptCount val="3"/>
                <c:pt idx="0">
                  <c:v>18.00546281128107</c:v>
                </c:pt>
                <c:pt idx="1">
                  <c:v>17.031758141193396</c:v>
                </c:pt>
                <c:pt idx="2">
                  <c:v>15.24822695035461</c:v>
                </c:pt>
              </c:numCache>
            </c:numRef>
          </c:val>
          <c:extLst>
            <c:ext xmlns:c16="http://schemas.microsoft.com/office/drawing/2014/chart" uri="{C3380CC4-5D6E-409C-BE32-E72D297353CC}">
              <c16:uniqueId val="{00000002-8886-47A1-911D-1EF5680B5D3A}"/>
            </c:ext>
          </c:extLst>
        </c:ser>
        <c:ser>
          <c:idx val="1"/>
          <c:order val="3"/>
          <c:tx>
            <c:strRef>
              <c:f>'[Master sheet.xlsx]Sheet8'!$W$6</c:f>
              <c:strCache>
                <c:ptCount val="1"/>
                <c:pt idx="0">
                  <c:v>Cellular processes &amp; signalling</c:v>
                </c:pt>
              </c:strCache>
            </c:strRef>
          </c:tx>
          <c:spPr>
            <a:solidFill>
              <a:schemeClr val="accent2"/>
            </a:solidFill>
            <a:ln>
              <a:noFill/>
            </a:ln>
            <a:effectLst/>
          </c:spPr>
          <c:invertIfNegative val="0"/>
          <c:cat>
            <c:strRef>
              <c:f>'[Master sheet.xlsx]Sheet8'!$U$7:$U$9</c:f>
              <c:strCache>
                <c:ptCount val="3"/>
                <c:pt idx="0">
                  <c:v>Parageobacillus (24)</c:v>
                </c:pt>
                <c:pt idx="1">
                  <c:v>Saccharococcus (11)</c:v>
                </c:pt>
                <c:pt idx="2">
                  <c:v>Geobacillus (1)</c:v>
                </c:pt>
              </c:strCache>
            </c:strRef>
          </c:cat>
          <c:val>
            <c:numRef>
              <c:f>'[Master sheet.xlsx]Sheet8'!$W$7:$W$9</c:f>
              <c:numCache>
                <c:formatCode>0.00</c:formatCode>
                <c:ptCount val="3"/>
                <c:pt idx="0">
                  <c:v>15.371921516979864</c:v>
                </c:pt>
                <c:pt idx="1">
                  <c:v>14.829721688773301</c:v>
                </c:pt>
                <c:pt idx="2">
                  <c:v>14.332151300236406</c:v>
                </c:pt>
              </c:numCache>
            </c:numRef>
          </c:val>
          <c:extLst>
            <c:ext xmlns:c16="http://schemas.microsoft.com/office/drawing/2014/chart" uri="{C3380CC4-5D6E-409C-BE32-E72D297353CC}">
              <c16:uniqueId val="{00000003-8886-47A1-911D-1EF5680B5D3A}"/>
            </c:ext>
          </c:extLst>
        </c:ser>
        <c:dLbls>
          <c:showLegendKey val="0"/>
          <c:showVal val="0"/>
          <c:showCatName val="0"/>
          <c:showSerName val="0"/>
          <c:showPercent val="0"/>
          <c:showBubbleSize val="0"/>
        </c:dLbls>
        <c:gapWidth val="150"/>
        <c:overlap val="100"/>
        <c:axId val="628682544"/>
        <c:axId val="1175221632"/>
      </c:barChart>
      <c:catAx>
        <c:axId val="628682544"/>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50" b="0" i="1" u="none" strike="noStrike" kern="1200" baseline="0">
                <a:solidFill>
                  <a:schemeClr val="tx1">
                    <a:lumMod val="65000"/>
                    <a:lumOff val="35000"/>
                  </a:schemeClr>
                </a:solidFill>
                <a:latin typeface="+mn-lt"/>
                <a:ea typeface="+mn-ea"/>
                <a:cs typeface="+mn-cs"/>
              </a:defRPr>
            </a:pPr>
            <a:endParaRPr lang="en-US"/>
          </a:p>
        </c:txPr>
        <c:crossAx val="1175221632"/>
        <c:crosses val="autoZero"/>
        <c:auto val="1"/>
        <c:lblAlgn val="ctr"/>
        <c:lblOffset val="100"/>
        <c:noMultiLvlLbl val="0"/>
      </c:catAx>
      <c:valAx>
        <c:axId val="117522163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28682544"/>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Sheet1!$Q$25</c:f>
              <c:strCache>
                <c:ptCount val="1"/>
                <c:pt idx="0">
                  <c:v>Info Storage</c:v>
                </c:pt>
              </c:strCache>
            </c:strRef>
          </c:tx>
          <c:spPr>
            <a:solidFill>
              <a:schemeClr val="accent1"/>
            </a:solidFill>
            <a:ln>
              <a:noFill/>
            </a:ln>
            <a:effectLst/>
          </c:spPr>
          <c:invertIfNegative val="0"/>
          <c:cat>
            <c:strRef>
              <c:f>Sheet1!$R$24:$X$24</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R$25:$X$25</c:f>
              <c:numCache>
                <c:formatCode>0.00</c:formatCode>
                <c:ptCount val="7"/>
                <c:pt idx="0">
                  <c:v>24.450691585363185</c:v>
                </c:pt>
                <c:pt idx="1">
                  <c:v>38.359893939808103</c:v>
                </c:pt>
                <c:pt idx="2">
                  <c:v>31.350892409487315</c:v>
                </c:pt>
                <c:pt idx="3">
                  <c:v>37.307979292148403</c:v>
                </c:pt>
                <c:pt idx="4">
                  <c:v>37.307979292148403</c:v>
                </c:pt>
                <c:pt idx="5">
                  <c:v>21.356055939588892</c:v>
                </c:pt>
                <c:pt idx="6">
                  <c:v>20.012539661429141</c:v>
                </c:pt>
              </c:numCache>
            </c:numRef>
          </c:val>
          <c:extLst>
            <c:ext xmlns:c16="http://schemas.microsoft.com/office/drawing/2014/chart" uri="{C3380CC4-5D6E-409C-BE32-E72D297353CC}">
              <c16:uniqueId val="{00000000-4A0E-468E-8B28-E09A396457F7}"/>
            </c:ext>
          </c:extLst>
        </c:ser>
        <c:ser>
          <c:idx val="1"/>
          <c:order val="1"/>
          <c:tx>
            <c:strRef>
              <c:f>Sheet1!$Q$26</c:f>
              <c:strCache>
                <c:ptCount val="1"/>
                <c:pt idx="0">
                  <c:v>Metabolism</c:v>
                </c:pt>
              </c:strCache>
            </c:strRef>
          </c:tx>
          <c:spPr>
            <a:solidFill>
              <a:schemeClr val="accent2"/>
            </a:solidFill>
            <a:ln>
              <a:noFill/>
            </a:ln>
            <a:effectLst/>
          </c:spPr>
          <c:invertIfNegative val="0"/>
          <c:cat>
            <c:strRef>
              <c:f>Sheet1!$R$24:$X$24</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R$26:$X$26</c:f>
              <c:numCache>
                <c:formatCode>0.00</c:formatCode>
                <c:ptCount val="7"/>
                <c:pt idx="0">
                  <c:v>53.26261936836994</c:v>
                </c:pt>
                <c:pt idx="1">
                  <c:v>32.391821337779845</c:v>
                </c:pt>
                <c:pt idx="2">
                  <c:v>43.092563925211067</c:v>
                </c:pt>
                <c:pt idx="3">
                  <c:v>34.614881652935793</c:v>
                </c:pt>
                <c:pt idx="4">
                  <c:v>34.614881652935793</c:v>
                </c:pt>
                <c:pt idx="5">
                  <c:v>60.139620833618501</c:v>
                </c:pt>
                <c:pt idx="6">
                  <c:v>56.301559857883845</c:v>
                </c:pt>
              </c:numCache>
            </c:numRef>
          </c:val>
          <c:extLst>
            <c:ext xmlns:c16="http://schemas.microsoft.com/office/drawing/2014/chart" uri="{C3380CC4-5D6E-409C-BE32-E72D297353CC}">
              <c16:uniqueId val="{00000001-4A0E-468E-8B28-E09A396457F7}"/>
            </c:ext>
          </c:extLst>
        </c:ser>
        <c:ser>
          <c:idx val="2"/>
          <c:order val="2"/>
          <c:tx>
            <c:strRef>
              <c:f>Sheet1!$Q$27</c:f>
              <c:strCache>
                <c:ptCount val="1"/>
                <c:pt idx="0">
                  <c:v>Cell processes</c:v>
                </c:pt>
              </c:strCache>
            </c:strRef>
          </c:tx>
          <c:spPr>
            <a:solidFill>
              <a:schemeClr val="accent3"/>
            </a:solidFill>
            <a:ln>
              <a:noFill/>
            </a:ln>
            <a:effectLst/>
          </c:spPr>
          <c:invertIfNegative val="0"/>
          <c:cat>
            <c:strRef>
              <c:f>Sheet1!$R$24:$X$24</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R$27:$X$27</c:f>
              <c:numCache>
                <c:formatCode>0.00</c:formatCode>
                <c:ptCount val="7"/>
                <c:pt idx="0">
                  <c:v>22.286689046266872</c:v>
                </c:pt>
                <c:pt idx="1">
                  <c:v>29.248558073422082</c:v>
                </c:pt>
                <c:pt idx="2">
                  <c:v>25.556543665301611</c:v>
                </c:pt>
                <c:pt idx="3">
                  <c:v>28.077139054915808</c:v>
                </c:pt>
                <c:pt idx="4">
                  <c:v>28.077139054915808</c:v>
                </c:pt>
                <c:pt idx="5">
                  <c:v>18.5043232267926</c:v>
                </c:pt>
                <c:pt idx="6">
                  <c:v>23.685900480687021</c:v>
                </c:pt>
              </c:numCache>
            </c:numRef>
          </c:val>
          <c:extLst>
            <c:ext xmlns:c16="http://schemas.microsoft.com/office/drawing/2014/chart" uri="{C3380CC4-5D6E-409C-BE32-E72D297353CC}">
              <c16:uniqueId val="{00000002-4A0E-468E-8B28-E09A396457F7}"/>
            </c:ext>
          </c:extLst>
        </c:ser>
        <c:dLbls>
          <c:showLegendKey val="0"/>
          <c:showVal val="0"/>
          <c:showCatName val="0"/>
          <c:showSerName val="0"/>
          <c:showPercent val="0"/>
          <c:showBubbleSize val="0"/>
        </c:dLbls>
        <c:gapWidth val="150"/>
        <c:overlap val="100"/>
        <c:axId val="628681584"/>
        <c:axId val="1336570544"/>
      </c:barChart>
      <c:catAx>
        <c:axId val="62868158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1" u="none" strike="noStrike" kern="1200" baseline="0">
                <a:solidFill>
                  <a:schemeClr val="tx1">
                    <a:lumMod val="65000"/>
                    <a:lumOff val="35000"/>
                  </a:schemeClr>
                </a:solidFill>
                <a:latin typeface="+mn-lt"/>
                <a:ea typeface="+mn-ea"/>
                <a:cs typeface="+mn-cs"/>
              </a:defRPr>
            </a:pPr>
            <a:endParaRPr lang="en-US"/>
          </a:p>
        </c:txPr>
        <c:crossAx val="1336570544"/>
        <c:crosses val="autoZero"/>
        <c:auto val="1"/>
        <c:lblAlgn val="ctr"/>
        <c:lblOffset val="100"/>
        <c:noMultiLvlLbl val="0"/>
      </c:catAx>
      <c:valAx>
        <c:axId val="1336570544"/>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28681584"/>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Sheet1!$L$3</c:f>
              <c:strCache>
                <c:ptCount val="1"/>
                <c:pt idx="0">
                  <c:v>C</c:v>
                </c:pt>
              </c:strCache>
            </c:strRef>
          </c:tx>
          <c:spPr>
            <a:solidFill>
              <a:schemeClr val="accent1"/>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3:$Z$3</c:f>
              <c:numCache>
                <c:formatCode>0.00</c:formatCode>
                <c:ptCount val="7"/>
                <c:pt idx="0">
                  <c:v>9.9494369613623572</c:v>
                </c:pt>
                <c:pt idx="1">
                  <c:v>4.2369406554957223</c:v>
                </c:pt>
                <c:pt idx="2">
                  <c:v>5.3980069460455482</c:v>
                </c:pt>
                <c:pt idx="3">
                  <c:v>2.9292988470683778</c:v>
                </c:pt>
                <c:pt idx="4">
                  <c:v>5.5769659766613593</c:v>
                </c:pt>
                <c:pt idx="5">
                  <c:v>8.5551981383888851</c:v>
                </c:pt>
                <c:pt idx="6">
                  <c:v>7.4097999354017441</c:v>
                </c:pt>
              </c:numCache>
            </c:numRef>
          </c:val>
          <c:extLst>
            <c:ext xmlns:c16="http://schemas.microsoft.com/office/drawing/2014/chart" uri="{C3380CC4-5D6E-409C-BE32-E72D297353CC}">
              <c16:uniqueId val="{00000000-0B87-45CA-9014-480EF8DF85A6}"/>
            </c:ext>
          </c:extLst>
        </c:ser>
        <c:ser>
          <c:idx val="1"/>
          <c:order val="1"/>
          <c:tx>
            <c:strRef>
              <c:f>Sheet1!$L$4</c:f>
              <c:strCache>
                <c:ptCount val="1"/>
                <c:pt idx="0">
                  <c:v>D</c:v>
                </c:pt>
              </c:strCache>
            </c:strRef>
          </c:tx>
          <c:spPr>
            <a:solidFill>
              <a:schemeClr val="accent2"/>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4:$Z$4</c:f>
              <c:numCache>
                <c:formatCode>0.00</c:formatCode>
                <c:ptCount val="7"/>
                <c:pt idx="0">
                  <c:v>2.6117272023576188</c:v>
                </c:pt>
                <c:pt idx="1">
                  <c:v>1.2300795451439193</c:v>
                </c:pt>
                <c:pt idx="2">
                  <c:v>2.1043077925262303</c:v>
                </c:pt>
                <c:pt idx="3">
                  <c:v>0.80808244057058698</c:v>
                </c:pt>
                <c:pt idx="4">
                  <c:v>1.5384733728720992</c:v>
                </c:pt>
                <c:pt idx="5">
                  <c:v>0.76046205674567868</c:v>
                </c:pt>
                <c:pt idx="6">
                  <c:v>1.8999487013850624</c:v>
                </c:pt>
              </c:numCache>
            </c:numRef>
          </c:val>
          <c:extLst>
            <c:ext xmlns:c16="http://schemas.microsoft.com/office/drawing/2014/chart" uri="{C3380CC4-5D6E-409C-BE32-E72D297353CC}">
              <c16:uniqueId val="{00000001-0B87-45CA-9014-480EF8DF85A6}"/>
            </c:ext>
          </c:extLst>
        </c:ser>
        <c:ser>
          <c:idx val="2"/>
          <c:order val="2"/>
          <c:tx>
            <c:strRef>
              <c:f>Sheet1!$L$5</c:f>
              <c:strCache>
                <c:ptCount val="1"/>
                <c:pt idx="0">
                  <c:v>E</c:v>
                </c:pt>
              </c:strCache>
            </c:strRef>
          </c:tx>
          <c:spPr>
            <a:solidFill>
              <a:schemeClr val="accent3"/>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5:$Z$5</c:f>
              <c:numCache>
                <c:formatCode>0.00</c:formatCode>
                <c:ptCount val="7"/>
                <c:pt idx="0">
                  <c:v>11.035567247249478</c:v>
                </c:pt>
                <c:pt idx="1">
                  <c:v>5.4213705819643003</c:v>
                </c:pt>
                <c:pt idx="2">
                  <c:v>10.06408074686458</c:v>
                </c:pt>
                <c:pt idx="3">
                  <c:v>3.0638445734233808</c:v>
                </c:pt>
                <c:pt idx="4">
                  <c:v>5.8331217932445636</c:v>
                </c:pt>
                <c:pt idx="5">
                  <c:v>10.836584308625921</c:v>
                </c:pt>
                <c:pt idx="6">
                  <c:v>14.439610130526475</c:v>
                </c:pt>
              </c:numCache>
            </c:numRef>
          </c:val>
          <c:extLst>
            <c:ext xmlns:c16="http://schemas.microsoft.com/office/drawing/2014/chart" uri="{C3380CC4-5D6E-409C-BE32-E72D297353CC}">
              <c16:uniqueId val="{00000002-0B87-45CA-9014-480EF8DF85A6}"/>
            </c:ext>
          </c:extLst>
        </c:ser>
        <c:ser>
          <c:idx val="3"/>
          <c:order val="3"/>
          <c:tx>
            <c:strRef>
              <c:f>Sheet1!$L$6</c:f>
              <c:strCache>
                <c:ptCount val="1"/>
                <c:pt idx="0">
                  <c:v>F</c:v>
                </c:pt>
              </c:strCache>
            </c:strRef>
          </c:tx>
          <c:spPr>
            <a:solidFill>
              <a:schemeClr val="accent4"/>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6:$Z$6</c:f>
              <c:numCache>
                <c:formatCode>0.00</c:formatCode>
                <c:ptCount val="7"/>
                <c:pt idx="0">
                  <c:v>5.671179067976543</c:v>
                </c:pt>
                <c:pt idx="1">
                  <c:v>2.5968345953038297</c:v>
                </c:pt>
                <c:pt idx="2">
                  <c:v>9.1491643153314359E-2</c:v>
                </c:pt>
                <c:pt idx="3">
                  <c:v>0.50505152535661679</c:v>
                </c:pt>
                <c:pt idx="4">
                  <c:v>0.96154585804506187</c:v>
                </c:pt>
                <c:pt idx="5">
                  <c:v>0.57034654255925898</c:v>
                </c:pt>
                <c:pt idx="6">
                  <c:v>3.6099025326316188</c:v>
                </c:pt>
              </c:numCache>
            </c:numRef>
          </c:val>
          <c:extLst>
            <c:ext xmlns:c16="http://schemas.microsoft.com/office/drawing/2014/chart" uri="{C3380CC4-5D6E-409C-BE32-E72D297353CC}">
              <c16:uniqueId val="{00000003-0B87-45CA-9014-480EF8DF85A6}"/>
            </c:ext>
          </c:extLst>
        </c:ser>
        <c:ser>
          <c:idx val="4"/>
          <c:order val="4"/>
          <c:tx>
            <c:strRef>
              <c:f>Sheet1!$L$7</c:f>
              <c:strCache>
                <c:ptCount val="1"/>
                <c:pt idx="0">
                  <c:v>G</c:v>
                </c:pt>
              </c:strCache>
            </c:strRef>
          </c:tx>
          <c:spPr>
            <a:solidFill>
              <a:schemeClr val="accent5"/>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7:$Z$7</c:f>
              <c:numCache>
                <c:formatCode>0.00</c:formatCode>
                <c:ptCount val="7"/>
                <c:pt idx="0">
                  <c:v>6.2681452856582842</c:v>
                </c:pt>
                <c:pt idx="1">
                  <c:v>6.9248011371402018</c:v>
                </c:pt>
                <c:pt idx="2">
                  <c:v>10.430047319477838</c:v>
                </c:pt>
                <c:pt idx="3">
                  <c:v>2.5587930480667636</c:v>
                </c:pt>
                <c:pt idx="4">
                  <c:v>4.8715759351995018</c:v>
                </c:pt>
                <c:pt idx="5">
                  <c:v>23.82755762401235</c:v>
                </c:pt>
                <c:pt idx="6">
                  <c:v>9.3728269336727905</c:v>
                </c:pt>
              </c:numCache>
            </c:numRef>
          </c:val>
          <c:extLst>
            <c:ext xmlns:c16="http://schemas.microsoft.com/office/drawing/2014/chart" uri="{C3380CC4-5D6E-409C-BE32-E72D297353CC}">
              <c16:uniqueId val="{00000004-0B87-45CA-9014-480EF8DF85A6}"/>
            </c:ext>
          </c:extLst>
        </c:ser>
        <c:ser>
          <c:idx val="5"/>
          <c:order val="5"/>
          <c:tx>
            <c:strRef>
              <c:f>Sheet1!$L$8</c:f>
              <c:strCache>
                <c:ptCount val="1"/>
                <c:pt idx="0">
                  <c:v>H</c:v>
                </c:pt>
              </c:strCache>
            </c:strRef>
          </c:tx>
          <c:spPr>
            <a:solidFill>
              <a:schemeClr val="accent6"/>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8:$Z$8</c:f>
              <c:numCache>
                <c:formatCode>0.00</c:formatCode>
                <c:ptCount val="7"/>
                <c:pt idx="0">
                  <c:v>6.790490726129808</c:v>
                </c:pt>
                <c:pt idx="1">
                  <c:v>2.1868080802558567</c:v>
                </c:pt>
                <c:pt idx="2">
                  <c:v>1.6468495767596587</c:v>
                </c:pt>
                <c:pt idx="3">
                  <c:v>0.80808244057058698</c:v>
                </c:pt>
                <c:pt idx="4">
                  <c:v>1.5384733728720992</c:v>
                </c:pt>
                <c:pt idx="5">
                  <c:v>1.7110396276777771</c:v>
                </c:pt>
                <c:pt idx="6">
                  <c:v>3.7998974027701249</c:v>
                </c:pt>
              </c:numCache>
            </c:numRef>
          </c:val>
          <c:extLst>
            <c:ext xmlns:c16="http://schemas.microsoft.com/office/drawing/2014/chart" uri="{C3380CC4-5D6E-409C-BE32-E72D297353CC}">
              <c16:uniqueId val="{00000005-0B87-45CA-9014-480EF8DF85A6}"/>
            </c:ext>
          </c:extLst>
        </c:ser>
        <c:ser>
          <c:idx val="6"/>
          <c:order val="6"/>
          <c:tx>
            <c:strRef>
              <c:f>Sheet1!$L$9</c:f>
              <c:strCache>
                <c:ptCount val="1"/>
                <c:pt idx="0">
                  <c:v>I</c:v>
                </c:pt>
              </c:strCache>
            </c:strRef>
          </c:tx>
          <c:spPr>
            <a:solidFill>
              <a:schemeClr val="accent1">
                <a:lumMod val="6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9:$Z$9</c:f>
              <c:numCache>
                <c:formatCode>0.00</c:formatCode>
                <c:ptCount val="7"/>
                <c:pt idx="0">
                  <c:v>3.7559124529142895</c:v>
                </c:pt>
                <c:pt idx="1">
                  <c:v>1.5034305551759015</c:v>
                </c:pt>
                <c:pt idx="2">
                  <c:v>4.0256322987458324</c:v>
                </c:pt>
                <c:pt idx="3">
                  <c:v>0.60606183042794026</c:v>
                </c:pt>
                <c:pt idx="4">
                  <c:v>1.1538550296540744</c:v>
                </c:pt>
                <c:pt idx="5">
                  <c:v>5.3232343972197516</c:v>
                </c:pt>
                <c:pt idx="6">
                  <c:v>4.5598768833241499</c:v>
                </c:pt>
              </c:numCache>
            </c:numRef>
          </c:val>
          <c:extLst>
            <c:ext xmlns:c16="http://schemas.microsoft.com/office/drawing/2014/chart" uri="{C3380CC4-5D6E-409C-BE32-E72D297353CC}">
              <c16:uniqueId val="{00000006-0B87-45CA-9014-480EF8DF85A6}"/>
            </c:ext>
          </c:extLst>
        </c:ser>
        <c:ser>
          <c:idx val="7"/>
          <c:order val="7"/>
          <c:tx>
            <c:strRef>
              <c:f>Sheet1!$L$10</c:f>
              <c:strCache>
                <c:ptCount val="1"/>
                <c:pt idx="0">
                  <c:v>J</c:v>
                </c:pt>
              </c:strCache>
            </c:strRef>
          </c:tx>
          <c:spPr>
            <a:solidFill>
              <a:schemeClr val="accent2">
                <a:lumMod val="6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10:$Z$10</c:f>
              <c:numCache>
                <c:formatCode>0.00</c:formatCode>
                <c:ptCount val="7"/>
                <c:pt idx="0">
                  <c:v>8.506768601964815</c:v>
                </c:pt>
                <c:pt idx="1">
                  <c:v>1.6401060601918926</c:v>
                </c:pt>
                <c:pt idx="2">
                  <c:v>1.2808830041464012</c:v>
                </c:pt>
                <c:pt idx="3">
                  <c:v>0.80808244057058698</c:v>
                </c:pt>
                <c:pt idx="4">
                  <c:v>1.5384733728720992</c:v>
                </c:pt>
                <c:pt idx="5">
                  <c:v>1.3308085993049379</c:v>
                </c:pt>
                <c:pt idx="6">
                  <c:v>1.1399692208310375</c:v>
                </c:pt>
              </c:numCache>
            </c:numRef>
          </c:val>
          <c:extLst>
            <c:ext xmlns:c16="http://schemas.microsoft.com/office/drawing/2014/chart" uri="{C3380CC4-5D6E-409C-BE32-E72D297353CC}">
              <c16:uniqueId val="{00000007-0B87-45CA-9014-480EF8DF85A6}"/>
            </c:ext>
          </c:extLst>
        </c:ser>
        <c:ser>
          <c:idx val="8"/>
          <c:order val="8"/>
          <c:tx>
            <c:strRef>
              <c:f>Sheet1!$L$11</c:f>
              <c:strCache>
                <c:ptCount val="1"/>
                <c:pt idx="0">
                  <c:v>K</c:v>
                </c:pt>
              </c:strCache>
            </c:strRef>
          </c:tx>
          <c:spPr>
            <a:solidFill>
              <a:schemeClr val="accent3">
                <a:lumMod val="6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11:$Z$11</c:f>
              <c:numCache>
                <c:formatCode>0.00</c:formatCode>
                <c:ptCount val="7"/>
                <c:pt idx="0">
                  <c:v>8.7969439309429482</c:v>
                </c:pt>
                <c:pt idx="1">
                  <c:v>10.842741163928601</c:v>
                </c:pt>
                <c:pt idx="2">
                  <c:v>12.656221980684283</c:v>
                </c:pt>
                <c:pt idx="3">
                  <c:v>5.3535461687801389</c:v>
                </c:pt>
                <c:pt idx="4">
                  <c:v>10.192386095277655</c:v>
                </c:pt>
                <c:pt idx="5">
                  <c:v>13.561319857945687</c:v>
                </c:pt>
                <c:pt idx="6">
                  <c:v>9.4362852202990517</c:v>
                </c:pt>
              </c:numCache>
            </c:numRef>
          </c:val>
          <c:extLst>
            <c:ext xmlns:c16="http://schemas.microsoft.com/office/drawing/2014/chart" uri="{C3380CC4-5D6E-409C-BE32-E72D297353CC}">
              <c16:uniqueId val="{00000008-0B87-45CA-9014-480EF8DF85A6}"/>
            </c:ext>
          </c:extLst>
        </c:ser>
        <c:ser>
          <c:idx val="9"/>
          <c:order val="9"/>
          <c:tx>
            <c:strRef>
              <c:f>Sheet1!$L$12</c:f>
              <c:strCache>
                <c:ptCount val="1"/>
                <c:pt idx="0">
                  <c:v>L</c:v>
                </c:pt>
              </c:strCache>
            </c:strRef>
          </c:tx>
          <c:spPr>
            <a:solidFill>
              <a:schemeClr val="accent4">
                <a:lumMod val="6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12:$Z$12</c:f>
              <c:numCache>
                <c:formatCode>0.00</c:formatCode>
                <c:ptCount val="7"/>
                <c:pt idx="0">
                  <c:v>7.1469790524554213</c:v>
                </c:pt>
                <c:pt idx="1">
                  <c:v>25.877046715687612</c:v>
                </c:pt>
                <c:pt idx="2">
                  <c:v>17.413787424656629</c:v>
                </c:pt>
                <c:pt idx="3">
                  <c:v>13.43437057448601</c:v>
                </c:pt>
                <c:pt idx="4">
                  <c:v>25.577119823998647</c:v>
                </c:pt>
                <c:pt idx="5">
                  <c:v>6.4639274823382689</c:v>
                </c:pt>
                <c:pt idx="6">
                  <c:v>9.4362852202990517</c:v>
                </c:pt>
              </c:numCache>
            </c:numRef>
          </c:val>
          <c:extLst>
            <c:ext xmlns:c16="http://schemas.microsoft.com/office/drawing/2014/chart" uri="{C3380CC4-5D6E-409C-BE32-E72D297353CC}">
              <c16:uniqueId val="{00000009-0B87-45CA-9014-480EF8DF85A6}"/>
            </c:ext>
          </c:extLst>
        </c:ser>
        <c:ser>
          <c:idx val="10"/>
          <c:order val="10"/>
          <c:tx>
            <c:strRef>
              <c:f>Sheet1!$L$13</c:f>
              <c:strCache>
                <c:ptCount val="1"/>
                <c:pt idx="0">
                  <c:v>M</c:v>
                </c:pt>
              </c:strCache>
            </c:strRef>
          </c:tx>
          <c:spPr>
            <a:solidFill>
              <a:schemeClr val="accent5">
                <a:lumMod val="6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13:$Z$13</c:f>
              <c:numCache>
                <c:formatCode>0.00</c:formatCode>
                <c:ptCount val="7"/>
                <c:pt idx="0">
                  <c:v>5.6960526603799497</c:v>
                </c:pt>
                <c:pt idx="1">
                  <c:v>8.0638547959434721</c:v>
                </c:pt>
                <c:pt idx="2">
                  <c:v>7.9597729543383497</c:v>
                </c:pt>
                <c:pt idx="3">
                  <c:v>2.6262679318544078</c:v>
                </c:pt>
                <c:pt idx="4">
                  <c:v>5.0000384618343219</c:v>
                </c:pt>
                <c:pt idx="5">
                  <c:v>4.5627723404740719</c:v>
                </c:pt>
                <c:pt idx="6">
                  <c:v>10.639712727756349</c:v>
                </c:pt>
              </c:numCache>
            </c:numRef>
          </c:val>
          <c:extLst>
            <c:ext xmlns:c16="http://schemas.microsoft.com/office/drawing/2014/chart" uri="{C3380CC4-5D6E-409C-BE32-E72D297353CC}">
              <c16:uniqueId val="{0000000A-0B87-45CA-9014-480EF8DF85A6}"/>
            </c:ext>
          </c:extLst>
        </c:ser>
        <c:ser>
          <c:idx val="11"/>
          <c:order val="11"/>
          <c:tx>
            <c:strRef>
              <c:f>Sheet1!$L$14</c:f>
              <c:strCache>
                <c:ptCount val="1"/>
                <c:pt idx="0">
                  <c:v>N</c:v>
                </c:pt>
              </c:strCache>
            </c:strRef>
          </c:tx>
          <c:spPr>
            <a:solidFill>
              <a:schemeClr val="accent6">
                <a:lumMod val="6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14:$Z$14</c:f>
              <c:numCache>
                <c:formatCode>0.00</c:formatCode>
                <c:ptCount val="7"/>
                <c:pt idx="0">
                  <c:v>2.6282930148982868</c:v>
                </c:pt>
                <c:pt idx="1">
                  <c:v>0.95672853511193734</c:v>
                </c:pt>
                <c:pt idx="2">
                  <c:v>1.6468495767596587</c:v>
                </c:pt>
                <c:pt idx="3">
                  <c:v>0.50505152535661679</c:v>
                </c:pt>
                <c:pt idx="4">
                  <c:v>0.96154585804506187</c:v>
                </c:pt>
                <c:pt idx="5">
                  <c:v>0.38023102837283934</c:v>
                </c:pt>
                <c:pt idx="6">
                  <c:v>0.37998974027701249</c:v>
                </c:pt>
              </c:numCache>
            </c:numRef>
          </c:val>
          <c:extLst>
            <c:ext xmlns:c16="http://schemas.microsoft.com/office/drawing/2014/chart" uri="{C3380CC4-5D6E-409C-BE32-E72D297353CC}">
              <c16:uniqueId val="{0000000B-0B87-45CA-9014-480EF8DF85A6}"/>
            </c:ext>
          </c:extLst>
        </c:ser>
        <c:ser>
          <c:idx val="12"/>
          <c:order val="12"/>
          <c:tx>
            <c:strRef>
              <c:f>Sheet1!$L$15</c:f>
              <c:strCache>
                <c:ptCount val="1"/>
                <c:pt idx="0">
                  <c:v>O</c:v>
                </c:pt>
              </c:strCache>
            </c:strRef>
          </c:tx>
          <c:spPr>
            <a:solidFill>
              <a:schemeClr val="accent1">
                <a:lumMod val="80000"/>
                <a:lumOff val="2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15:$Z$15</c:f>
              <c:numCache>
                <c:formatCode>0.00</c:formatCode>
                <c:ptCount val="7"/>
                <c:pt idx="0">
                  <c:v>3.8636648552058435</c:v>
                </c:pt>
                <c:pt idx="1">
                  <c:v>4.920318180575677</c:v>
                </c:pt>
                <c:pt idx="2">
                  <c:v>2.7447492945994312</c:v>
                </c:pt>
                <c:pt idx="3">
                  <c:v>2.5252576267830844</c:v>
                </c:pt>
                <c:pt idx="4">
                  <c:v>4.8077292902253097</c:v>
                </c:pt>
                <c:pt idx="5">
                  <c:v>2.851732712796295</c:v>
                </c:pt>
                <c:pt idx="6">
                  <c:v>2.8499230520775938</c:v>
                </c:pt>
              </c:numCache>
            </c:numRef>
          </c:val>
          <c:extLst>
            <c:ext xmlns:c16="http://schemas.microsoft.com/office/drawing/2014/chart" uri="{C3380CC4-5D6E-409C-BE32-E72D297353CC}">
              <c16:uniqueId val="{0000000C-0B87-45CA-9014-480EF8DF85A6}"/>
            </c:ext>
          </c:extLst>
        </c:ser>
        <c:ser>
          <c:idx val="13"/>
          <c:order val="13"/>
          <c:tx>
            <c:strRef>
              <c:f>Sheet1!$L$16</c:f>
              <c:strCache>
                <c:ptCount val="1"/>
                <c:pt idx="0">
                  <c:v>P</c:v>
                </c:pt>
              </c:strCache>
            </c:strRef>
          </c:tx>
          <c:spPr>
            <a:solidFill>
              <a:schemeClr val="accent2">
                <a:lumMod val="80000"/>
                <a:lumOff val="2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16:$Z$16</c:f>
              <c:numCache>
                <c:formatCode>0.00</c:formatCode>
                <c:ptCount val="7"/>
                <c:pt idx="0">
                  <c:v>7.603011495579465</c:v>
                </c:pt>
                <c:pt idx="1">
                  <c:v>7.1981521471721832</c:v>
                </c:pt>
                <c:pt idx="2">
                  <c:v>9.3321476016380664</c:v>
                </c:pt>
                <c:pt idx="3">
                  <c:v>6.4981949458483745</c:v>
                </c:pt>
                <c:pt idx="4">
                  <c:v>12.371633627950983</c:v>
                </c:pt>
                <c:pt idx="5">
                  <c:v>7.9848515958296273</c:v>
                </c:pt>
                <c:pt idx="6">
                  <c:v>9.4997435069253129</c:v>
                </c:pt>
              </c:numCache>
            </c:numRef>
          </c:val>
          <c:extLst>
            <c:ext xmlns:c16="http://schemas.microsoft.com/office/drawing/2014/chart" uri="{C3380CC4-5D6E-409C-BE32-E72D297353CC}">
              <c16:uniqueId val="{0000000D-0B87-45CA-9014-480EF8DF85A6}"/>
            </c:ext>
          </c:extLst>
        </c:ser>
        <c:ser>
          <c:idx val="14"/>
          <c:order val="14"/>
          <c:tx>
            <c:strRef>
              <c:f>Sheet1!$L$17</c:f>
              <c:strCache>
                <c:ptCount val="1"/>
                <c:pt idx="0">
                  <c:v>Q</c:v>
                </c:pt>
              </c:strCache>
            </c:strRef>
          </c:tx>
          <c:spPr>
            <a:solidFill>
              <a:schemeClr val="accent3">
                <a:lumMod val="80000"/>
                <a:lumOff val="2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17:$Z$17</c:f>
              <c:numCache>
                <c:formatCode>0.00</c:formatCode>
                <c:ptCount val="7"/>
                <c:pt idx="0">
                  <c:v>2.1888761314997183</c:v>
                </c:pt>
                <c:pt idx="1">
                  <c:v>2.3234835852718478</c:v>
                </c:pt>
                <c:pt idx="2">
                  <c:v>2.1043077925262303</c:v>
                </c:pt>
                <c:pt idx="3">
                  <c:v>1.2121236608558805</c:v>
                </c:pt>
                <c:pt idx="4">
                  <c:v>2.3077100593081488</c:v>
                </c:pt>
                <c:pt idx="5">
                  <c:v>1.3308085993049379</c:v>
                </c:pt>
                <c:pt idx="6">
                  <c:v>3.6099025326316188</c:v>
                </c:pt>
              </c:numCache>
            </c:numRef>
          </c:val>
          <c:extLst>
            <c:ext xmlns:c16="http://schemas.microsoft.com/office/drawing/2014/chart" uri="{C3380CC4-5D6E-409C-BE32-E72D297353CC}">
              <c16:uniqueId val="{0000000E-0B87-45CA-9014-480EF8DF85A6}"/>
            </c:ext>
          </c:extLst>
        </c:ser>
        <c:ser>
          <c:idx val="15"/>
          <c:order val="15"/>
          <c:tx>
            <c:strRef>
              <c:f>Sheet1!$L$18</c:f>
              <c:strCache>
                <c:ptCount val="1"/>
                <c:pt idx="0">
                  <c:v>T</c:v>
                </c:pt>
              </c:strCache>
            </c:strRef>
          </c:tx>
          <c:spPr>
            <a:solidFill>
              <a:schemeClr val="accent4">
                <a:lumMod val="80000"/>
                <a:lumOff val="2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18:$Z$18</c:f>
              <c:numCache>
                <c:formatCode>0.00</c:formatCode>
                <c:ptCount val="7"/>
                <c:pt idx="0">
                  <c:v>4.2285107085790017</c:v>
                </c:pt>
                <c:pt idx="1">
                  <c:v>3.8269141404477494</c:v>
                </c:pt>
                <c:pt idx="2">
                  <c:v>4.6964490263459338</c:v>
                </c:pt>
                <c:pt idx="3">
                  <c:v>3.7373812876389647</c:v>
                </c:pt>
                <c:pt idx="4">
                  <c:v>7.1154393495334576</c:v>
                </c:pt>
                <c:pt idx="5">
                  <c:v>6.3369303188617403</c:v>
                </c:pt>
                <c:pt idx="6">
                  <c:v>5.6363878175289264</c:v>
                </c:pt>
              </c:numCache>
            </c:numRef>
          </c:val>
          <c:extLst>
            <c:ext xmlns:c16="http://schemas.microsoft.com/office/drawing/2014/chart" uri="{C3380CC4-5D6E-409C-BE32-E72D297353CC}">
              <c16:uniqueId val="{0000000F-0B87-45CA-9014-480EF8DF85A6}"/>
            </c:ext>
          </c:extLst>
        </c:ser>
        <c:ser>
          <c:idx val="16"/>
          <c:order val="16"/>
          <c:tx>
            <c:strRef>
              <c:f>Sheet1!$L$19</c:f>
              <c:strCache>
                <c:ptCount val="1"/>
                <c:pt idx="0">
                  <c:v>U</c:v>
                </c:pt>
              </c:strCache>
            </c:strRef>
          </c:tx>
          <c:spPr>
            <a:solidFill>
              <a:schemeClr val="accent5">
                <a:lumMod val="80000"/>
                <a:lumOff val="2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19:$Z$19</c:f>
              <c:numCache>
                <c:formatCode>0.00</c:formatCode>
                <c:ptCount val="7"/>
                <c:pt idx="0">
                  <c:v>1.7660250606418182</c:v>
                </c:pt>
                <c:pt idx="1">
                  <c:v>1.3667550501599104</c:v>
                </c:pt>
                <c:pt idx="2">
                  <c:v>1.8298328630662875</c:v>
                </c:pt>
                <c:pt idx="3">
                  <c:v>0.30303091521397013</c:v>
                </c:pt>
                <c:pt idx="4">
                  <c:v>0.57692751482703719</c:v>
                </c:pt>
                <c:pt idx="5">
                  <c:v>0.95057757093209827</c:v>
                </c:pt>
                <c:pt idx="6">
                  <c:v>0.75997948055402498</c:v>
                </c:pt>
              </c:numCache>
            </c:numRef>
          </c:val>
          <c:extLst>
            <c:ext xmlns:c16="http://schemas.microsoft.com/office/drawing/2014/chart" uri="{C3380CC4-5D6E-409C-BE32-E72D297353CC}">
              <c16:uniqueId val="{00000010-0B87-45CA-9014-480EF8DF85A6}"/>
            </c:ext>
          </c:extLst>
        </c:ser>
        <c:ser>
          <c:idx val="17"/>
          <c:order val="17"/>
          <c:tx>
            <c:strRef>
              <c:f>Sheet1!$L$20</c:f>
              <c:strCache>
                <c:ptCount val="1"/>
                <c:pt idx="0">
                  <c:v>V</c:v>
                </c:pt>
              </c:strCache>
            </c:strRef>
          </c:tx>
          <c:spPr>
            <a:solidFill>
              <a:schemeClr val="accent6">
                <a:lumMod val="80000"/>
                <a:lumOff val="20000"/>
              </a:schemeClr>
            </a:solidFill>
            <a:ln>
              <a:noFill/>
            </a:ln>
            <a:effectLst/>
          </c:spPr>
          <c:invertIfNegative val="0"/>
          <c:cat>
            <c:strRef>
              <c:f>Sheet1!$T$2:$Z$2</c:f>
              <c:strCache>
                <c:ptCount val="7"/>
                <c:pt idx="0">
                  <c:v>Core</c:v>
                </c:pt>
                <c:pt idx="1">
                  <c:v>P. toebii_only</c:v>
                </c:pt>
                <c:pt idx="2">
                  <c:v>P. thermoglucosidasius_only</c:v>
                </c:pt>
                <c:pt idx="3">
                  <c:v>S. caldoxylosilyticus_only</c:v>
                </c:pt>
                <c:pt idx="4">
                  <c:v>P. thermoglucosidasius + P. toebii</c:v>
                </c:pt>
                <c:pt idx="5">
                  <c:v>P. thermoglucosidasius + S. caldoxylosilyticus</c:v>
                </c:pt>
                <c:pt idx="6">
                  <c:v>P. toebii + S. caldoxylosilyticus</c:v>
                </c:pt>
              </c:strCache>
            </c:strRef>
          </c:cat>
          <c:val>
            <c:numRef>
              <c:f>Sheet1!$T$20:$Z$20</c:f>
              <c:numCache>
                <c:formatCode>0.00</c:formatCode>
                <c:ptCount val="7"/>
                <c:pt idx="0">
                  <c:v>1.4924155442043534</c:v>
                </c:pt>
                <c:pt idx="1">
                  <c:v>8.8839078260394189</c:v>
                </c:pt>
                <c:pt idx="2">
                  <c:v>4.5745821576657182</c:v>
                </c:pt>
                <c:pt idx="3">
                  <c:v>4.2424328129955811</c:v>
                </c:pt>
                <c:pt idx="4">
                  <c:v>8.0769852075785202</c:v>
                </c:pt>
                <c:pt idx="5">
                  <c:v>2.6616171986098758</c:v>
                </c:pt>
                <c:pt idx="6">
                  <c:v>1.51995896110805</c:v>
                </c:pt>
              </c:numCache>
            </c:numRef>
          </c:val>
          <c:extLst>
            <c:ext xmlns:c16="http://schemas.microsoft.com/office/drawing/2014/chart" uri="{C3380CC4-5D6E-409C-BE32-E72D297353CC}">
              <c16:uniqueId val="{00000011-0B87-45CA-9014-480EF8DF85A6}"/>
            </c:ext>
          </c:extLst>
        </c:ser>
        <c:dLbls>
          <c:showLegendKey val="0"/>
          <c:showVal val="0"/>
          <c:showCatName val="0"/>
          <c:showSerName val="0"/>
          <c:showPercent val="0"/>
          <c:showBubbleSize val="0"/>
        </c:dLbls>
        <c:gapWidth val="150"/>
        <c:overlap val="100"/>
        <c:axId val="1135342672"/>
        <c:axId val="1140164656"/>
      </c:barChart>
      <c:catAx>
        <c:axId val="113534267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140164656"/>
        <c:crosses val="autoZero"/>
        <c:auto val="1"/>
        <c:lblAlgn val="ctr"/>
        <c:lblOffset val="100"/>
        <c:noMultiLvlLbl val="0"/>
      </c:catAx>
      <c:valAx>
        <c:axId val="1140164656"/>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135342672"/>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8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iagrams/colors1.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C1A08B5-88CB-4A4A-BA75-EFEC8E9A0831}" type="doc">
      <dgm:prSet loTypeId="urn:microsoft.com/office/officeart/2005/8/layout/venn1" loCatId="relationship" qsTypeId="urn:microsoft.com/office/officeart/2005/8/quickstyle/simple1" qsCatId="simple" csTypeId="urn:microsoft.com/office/officeart/2005/8/colors/colorful4" csCatId="colorful" phldr="1"/>
      <dgm:spPr/>
    </dgm:pt>
    <dgm:pt modelId="{1FA9BB48-79E1-491B-BF64-36D9699823E7}">
      <dgm:prSet phldrT="[Text]" custT="1"/>
      <dgm:spPr/>
      <dgm:t>
        <a:bodyPr/>
        <a:lstStyle/>
        <a:p>
          <a:r>
            <a:rPr lang="en-ZA" sz="1100" i="1" dirty="0"/>
            <a:t>S. </a:t>
          </a:r>
          <a:r>
            <a:rPr lang="en-ZA" sz="1100" i="1" dirty="0" err="1"/>
            <a:t>caldoxylosilyticus</a:t>
          </a:r>
          <a:r>
            <a:rPr lang="en-ZA" sz="1100" i="1" dirty="0"/>
            <a:t> </a:t>
          </a:r>
        </a:p>
      </dgm:t>
    </dgm:pt>
    <dgm:pt modelId="{70FD25E3-5D99-48FE-872C-305492185752}" type="parTrans" cxnId="{AC6151F5-100C-4578-8CC8-B8A003BB4331}">
      <dgm:prSet/>
      <dgm:spPr/>
      <dgm:t>
        <a:bodyPr/>
        <a:lstStyle/>
        <a:p>
          <a:endParaRPr lang="en-ZA"/>
        </a:p>
      </dgm:t>
    </dgm:pt>
    <dgm:pt modelId="{4DF65BB9-EA7F-4BD2-97E4-C8D794A2FE81}" type="sibTrans" cxnId="{AC6151F5-100C-4578-8CC8-B8A003BB4331}">
      <dgm:prSet/>
      <dgm:spPr/>
      <dgm:t>
        <a:bodyPr/>
        <a:lstStyle/>
        <a:p>
          <a:endParaRPr lang="en-ZA"/>
        </a:p>
      </dgm:t>
    </dgm:pt>
    <dgm:pt modelId="{E16D43B0-402B-4254-84DE-BCBE522EA0AD}">
      <dgm:prSet phldrT="[Text]" custT="1"/>
      <dgm:spPr/>
      <dgm:t>
        <a:bodyPr/>
        <a:lstStyle/>
        <a:p>
          <a:r>
            <a:rPr lang="en-ZA" sz="1100" i="1" dirty="0"/>
            <a:t>P. </a:t>
          </a:r>
          <a:r>
            <a:rPr lang="en-ZA" sz="1100" i="1" dirty="0" err="1"/>
            <a:t>toebii</a:t>
          </a:r>
          <a:endParaRPr lang="en-ZA" sz="1100" i="1" dirty="0"/>
        </a:p>
      </dgm:t>
    </dgm:pt>
    <dgm:pt modelId="{1CD80AB7-BD7A-45B0-BC83-42D03A7516BB}" type="parTrans" cxnId="{7D27038F-E590-4A7C-83B2-90050D83ECE4}">
      <dgm:prSet/>
      <dgm:spPr/>
      <dgm:t>
        <a:bodyPr/>
        <a:lstStyle/>
        <a:p>
          <a:endParaRPr lang="en-ZA"/>
        </a:p>
      </dgm:t>
    </dgm:pt>
    <dgm:pt modelId="{4E9E7589-CA5E-4DE3-B888-B3FDC232BC30}" type="sibTrans" cxnId="{7D27038F-E590-4A7C-83B2-90050D83ECE4}">
      <dgm:prSet/>
      <dgm:spPr/>
      <dgm:t>
        <a:bodyPr/>
        <a:lstStyle/>
        <a:p>
          <a:endParaRPr lang="en-ZA"/>
        </a:p>
      </dgm:t>
    </dgm:pt>
    <dgm:pt modelId="{F94E9252-9C84-4713-A7EF-5062D2CD4786}">
      <dgm:prSet phldrT="[Text]" custT="1"/>
      <dgm:spPr/>
      <dgm:t>
        <a:bodyPr/>
        <a:lstStyle/>
        <a:p>
          <a:r>
            <a:rPr lang="en-ZA" sz="1100" i="1" dirty="0"/>
            <a:t>P. thermoglucosidasius</a:t>
          </a:r>
        </a:p>
      </dgm:t>
    </dgm:pt>
    <dgm:pt modelId="{FEB46F3D-5B60-4BAF-A68C-CDAC08A3D30B}" type="parTrans" cxnId="{A13A1387-10D5-47EB-9871-3D80FD3199AE}">
      <dgm:prSet/>
      <dgm:spPr/>
      <dgm:t>
        <a:bodyPr/>
        <a:lstStyle/>
        <a:p>
          <a:endParaRPr lang="en-ZA"/>
        </a:p>
      </dgm:t>
    </dgm:pt>
    <dgm:pt modelId="{EF32F196-E0DD-4D06-A754-B91D45D23147}" type="sibTrans" cxnId="{A13A1387-10D5-47EB-9871-3D80FD3199AE}">
      <dgm:prSet/>
      <dgm:spPr/>
      <dgm:t>
        <a:bodyPr/>
        <a:lstStyle/>
        <a:p>
          <a:endParaRPr lang="en-ZA"/>
        </a:p>
      </dgm:t>
    </dgm:pt>
    <dgm:pt modelId="{04DB800A-A5B7-41DA-A5A2-7EA8238AA893}" type="pres">
      <dgm:prSet presAssocID="{6C1A08B5-88CB-4A4A-BA75-EFEC8E9A0831}" presName="compositeShape" presStyleCnt="0">
        <dgm:presLayoutVars>
          <dgm:chMax val="7"/>
          <dgm:dir/>
          <dgm:resizeHandles val="exact"/>
        </dgm:presLayoutVars>
      </dgm:prSet>
      <dgm:spPr/>
    </dgm:pt>
    <dgm:pt modelId="{68FAFE2D-3DD5-4DDA-B4ED-E809D021C70D}" type="pres">
      <dgm:prSet presAssocID="{1FA9BB48-79E1-491B-BF64-36D9699823E7}" presName="circ1" presStyleLbl="vennNode1" presStyleIdx="0" presStyleCnt="3"/>
      <dgm:spPr/>
    </dgm:pt>
    <dgm:pt modelId="{CFE9CF0E-2347-4F32-B144-783D241039D5}" type="pres">
      <dgm:prSet presAssocID="{1FA9BB48-79E1-491B-BF64-36D9699823E7}" presName="circ1Tx" presStyleLbl="revTx" presStyleIdx="0" presStyleCnt="0">
        <dgm:presLayoutVars>
          <dgm:chMax val="0"/>
          <dgm:chPref val="0"/>
          <dgm:bulletEnabled val="1"/>
        </dgm:presLayoutVars>
      </dgm:prSet>
      <dgm:spPr/>
    </dgm:pt>
    <dgm:pt modelId="{304AC77E-7A73-470B-BDFD-BA44C6079A32}" type="pres">
      <dgm:prSet presAssocID="{E16D43B0-402B-4254-84DE-BCBE522EA0AD}" presName="circ2" presStyleLbl="vennNode1" presStyleIdx="1" presStyleCnt="3"/>
      <dgm:spPr/>
    </dgm:pt>
    <dgm:pt modelId="{BE432A25-B786-4DBC-A025-52D735807E22}" type="pres">
      <dgm:prSet presAssocID="{E16D43B0-402B-4254-84DE-BCBE522EA0AD}" presName="circ2Tx" presStyleLbl="revTx" presStyleIdx="0" presStyleCnt="0">
        <dgm:presLayoutVars>
          <dgm:chMax val="0"/>
          <dgm:chPref val="0"/>
          <dgm:bulletEnabled val="1"/>
        </dgm:presLayoutVars>
      </dgm:prSet>
      <dgm:spPr/>
    </dgm:pt>
    <dgm:pt modelId="{8173DA53-CBD5-42DB-816D-A2BCBF33BCE2}" type="pres">
      <dgm:prSet presAssocID="{F94E9252-9C84-4713-A7EF-5062D2CD4786}" presName="circ3" presStyleLbl="vennNode1" presStyleIdx="2" presStyleCnt="3"/>
      <dgm:spPr/>
    </dgm:pt>
    <dgm:pt modelId="{BB37C04D-F692-4146-8448-668A86C238AE}" type="pres">
      <dgm:prSet presAssocID="{F94E9252-9C84-4713-A7EF-5062D2CD4786}" presName="circ3Tx" presStyleLbl="revTx" presStyleIdx="0" presStyleCnt="0">
        <dgm:presLayoutVars>
          <dgm:chMax val="0"/>
          <dgm:chPref val="0"/>
          <dgm:bulletEnabled val="1"/>
        </dgm:presLayoutVars>
      </dgm:prSet>
      <dgm:spPr/>
    </dgm:pt>
  </dgm:ptLst>
  <dgm:cxnLst>
    <dgm:cxn modelId="{2E3C7000-62C5-48A4-A5D7-E10268E3E8E9}" type="presOf" srcId="{1FA9BB48-79E1-491B-BF64-36D9699823E7}" destId="{68FAFE2D-3DD5-4DDA-B4ED-E809D021C70D}" srcOrd="0" destOrd="0" presId="urn:microsoft.com/office/officeart/2005/8/layout/venn1"/>
    <dgm:cxn modelId="{4347081E-1357-4F77-9C65-58AFCF4AF65D}" type="presOf" srcId="{6C1A08B5-88CB-4A4A-BA75-EFEC8E9A0831}" destId="{04DB800A-A5B7-41DA-A5A2-7EA8238AA893}" srcOrd="0" destOrd="0" presId="urn:microsoft.com/office/officeart/2005/8/layout/venn1"/>
    <dgm:cxn modelId="{A0889A1F-E504-4BC6-8181-E4DAAC3426C1}" type="presOf" srcId="{E16D43B0-402B-4254-84DE-BCBE522EA0AD}" destId="{BE432A25-B786-4DBC-A025-52D735807E22}" srcOrd="1" destOrd="0" presId="urn:microsoft.com/office/officeart/2005/8/layout/venn1"/>
    <dgm:cxn modelId="{351D5E47-122C-4486-8B65-37B70C386087}" type="presOf" srcId="{F94E9252-9C84-4713-A7EF-5062D2CD4786}" destId="{8173DA53-CBD5-42DB-816D-A2BCBF33BCE2}" srcOrd="0" destOrd="0" presId="urn:microsoft.com/office/officeart/2005/8/layout/venn1"/>
    <dgm:cxn modelId="{A13A1387-10D5-47EB-9871-3D80FD3199AE}" srcId="{6C1A08B5-88CB-4A4A-BA75-EFEC8E9A0831}" destId="{F94E9252-9C84-4713-A7EF-5062D2CD4786}" srcOrd="2" destOrd="0" parTransId="{FEB46F3D-5B60-4BAF-A68C-CDAC08A3D30B}" sibTransId="{EF32F196-E0DD-4D06-A754-B91D45D23147}"/>
    <dgm:cxn modelId="{B1FEF389-1B3F-4C55-9FCE-61EAA26E80DD}" type="presOf" srcId="{F94E9252-9C84-4713-A7EF-5062D2CD4786}" destId="{BB37C04D-F692-4146-8448-668A86C238AE}" srcOrd="1" destOrd="0" presId="urn:microsoft.com/office/officeart/2005/8/layout/venn1"/>
    <dgm:cxn modelId="{7D27038F-E590-4A7C-83B2-90050D83ECE4}" srcId="{6C1A08B5-88CB-4A4A-BA75-EFEC8E9A0831}" destId="{E16D43B0-402B-4254-84DE-BCBE522EA0AD}" srcOrd="1" destOrd="0" parTransId="{1CD80AB7-BD7A-45B0-BC83-42D03A7516BB}" sibTransId="{4E9E7589-CA5E-4DE3-B888-B3FDC232BC30}"/>
    <dgm:cxn modelId="{659F40B6-8B22-48B6-96A3-9C69383327D2}" type="presOf" srcId="{1FA9BB48-79E1-491B-BF64-36D9699823E7}" destId="{CFE9CF0E-2347-4F32-B144-783D241039D5}" srcOrd="1" destOrd="0" presId="urn:microsoft.com/office/officeart/2005/8/layout/venn1"/>
    <dgm:cxn modelId="{035C30BB-47B4-48C5-B92E-6648C9F2031A}" type="presOf" srcId="{E16D43B0-402B-4254-84DE-BCBE522EA0AD}" destId="{304AC77E-7A73-470B-BDFD-BA44C6079A32}" srcOrd="0" destOrd="0" presId="urn:microsoft.com/office/officeart/2005/8/layout/venn1"/>
    <dgm:cxn modelId="{AC6151F5-100C-4578-8CC8-B8A003BB4331}" srcId="{6C1A08B5-88CB-4A4A-BA75-EFEC8E9A0831}" destId="{1FA9BB48-79E1-491B-BF64-36D9699823E7}" srcOrd="0" destOrd="0" parTransId="{70FD25E3-5D99-48FE-872C-305492185752}" sibTransId="{4DF65BB9-EA7F-4BD2-97E4-C8D794A2FE81}"/>
    <dgm:cxn modelId="{7A3D551B-F3FF-4A83-94F9-6C3C1E1B622D}" type="presParOf" srcId="{04DB800A-A5B7-41DA-A5A2-7EA8238AA893}" destId="{68FAFE2D-3DD5-4DDA-B4ED-E809D021C70D}" srcOrd="0" destOrd="0" presId="urn:microsoft.com/office/officeart/2005/8/layout/venn1"/>
    <dgm:cxn modelId="{EC8F7A3E-73DB-4E32-A30F-BCD6CE732D5F}" type="presParOf" srcId="{04DB800A-A5B7-41DA-A5A2-7EA8238AA893}" destId="{CFE9CF0E-2347-4F32-B144-783D241039D5}" srcOrd="1" destOrd="0" presId="urn:microsoft.com/office/officeart/2005/8/layout/venn1"/>
    <dgm:cxn modelId="{DA8C7B6B-2917-4561-9066-E3FACBB3F623}" type="presParOf" srcId="{04DB800A-A5B7-41DA-A5A2-7EA8238AA893}" destId="{304AC77E-7A73-470B-BDFD-BA44C6079A32}" srcOrd="2" destOrd="0" presId="urn:microsoft.com/office/officeart/2005/8/layout/venn1"/>
    <dgm:cxn modelId="{4CF47C35-69A7-4638-AA8D-E288611721B1}" type="presParOf" srcId="{04DB800A-A5B7-41DA-A5A2-7EA8238AA893}" destId="{BE432A25-B786-4DBC-A025-52D735807E22}" srcOrd="3" destOrd="0" presId="urn:microsoft.com/office/officeart/2005/8/layout/venn1"/>
    <dgm:cxn modelId="{EB211830-8BDC-4242-84A3-B0A9FF8F5F72}" type="presParOf" srcId="{04DB800A-A5B7-41DA-A5A2-7EA8238AA893}" destId="{8173DA53-CBD5-42DB-816D-A2BCBF33BCE2}" srcOrd="4" destOrd="0" presId="urn:microsoft.com/office/officeart/2005/8/layout/venn1"/>
    <dgm:cxn modelId="{72E7BEE4-DF92-48E7-B215-DFB1D7F9FB27}" type="presParOf" srcId="{04DB800A-A5B7-41DA-A5A2-7EA8238AA893}" destId="{BB37C04D-F692-4146-8448-668A86C238AE}" srcOrd="5" destOrd="0" presId="urn:microsoft.com/office/officeart/2005/8/layout/venn1"/>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8FAFE2D-3DD5-4DDA-B4ED-E809D021C70D}">
      <dsp:nvSpPr>
        <dsp:cNvPr id="0" name=""/>
        <dsp:cNvSpPr/>
      </dsp:nvSpPr>
      <dsp:spPr>
        <a:xfrm>
          <a:off x="1771425" y="40677"/>
          <a:ext cx="1952512" cy="1952512"/>
        </a:xfrm>
        <a:prstGeom prst="ellipse">
          <a:avLst/>
        </a:prstGeom>
        <a:solidFill>
          <a:schemeClr val="accent4">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r>
            <a:rPr lang="en-ZA" sz="1100" i="1" kern="1200" dirty="0"/>
            <a:t>S. </a:t>
          </a:r>
          <a:r>
            <a:rPr lang="en-ZA" sz="1100" i="1" kern="1200" dirty="0" err="1"/>
            <a:t>caldoxylosilyticus</a:t>
          </a:r>
          <a:r>
            <a:rPr lang="en-ZA" sz="1100" i="1" kern="1200" dirty="0"/>
            <a:t> </a:t>
          </a:r>
        </a:p>
      </dsp:txBody>
      <dsp:txXfrm>
        <a:off x="2031760" y="382367"/>
        <a:ext cx="1431842" cy="878630"/>
      </dsp:txXfrm>
    </dsp:sp>
    <dsp:sp modelId="{304AC77E-7A73-470B-BDFD-BA44C6079A32}">
      <dsp:nvSpPr>
        <dsp:cNvPr id="0" name=""/>
        <dsp:cNvSpPr/>
      </dsp:nvSpPr>
      <dsp:spPr>
        <a:xfrm>
          <a:off x="2475957" y="1260997"/>
          <a:ext cx="1952512" cy="1952512"/>
        </a:xfrm>
        <a:prstGeom prst="ellipse">
          <a:avLst/>
        </a:prstGeom>
        <a:solidFill>
          <a:schemeClr val="accent4">
            <a:alpha val="50000"/>
            <a:hueOff val="4900445"/>
            <a:satOff val="-20388"/>
            <a:lumOff val="480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r>
            <a:rPr lang="en-ZA" sz="1100" i="1" kern="1200" dirty="0"/>
            <a:t>P. </a:t>
          </a:r>
          <a:r>
            <a:rPr lang="en-ZA" sz="1100" i="1" kern="1200" dirty="0" err="1"/>
            <a:t>toebii</a:t>
          </a:r>
          <a:endParaRPr lang="en-ZA" sz="1100" i="1" kern="1200" dirty="0"/>
        </a:p>
      </dsp:txBody>
      <dsp:txXfrm>
        <a:off x="3073100" y="1765396"/>
        <a:ext cx="1171507" cy="1073882"/>
      </dsp:txXfrm>
    </dsp:sp>
    <dsp:sp modelId="{8173DA53-CBD5-42DB-816D-A2BCBF33BCE2}">
      <dsp:nvSpPr>
        <dsp:cNvPr id="0" name=""/>
        <dsp:cNvSpPr/>
      </dsp:nvSpPr>
      <dsp:spPr>
        <a:xfrm>
          <a:off x="1066893" y="1260997"/>
          <a:ext cx="1952512" cy="1952512"/>
        </a:xfrm>
        <a:prstGeom prst="ellipse">
          <a:avLst/>
        </a:prstGeom>
        <a:solidFill>
          <a:schemeClr val="accent4">
            <a:alpha val="50000"/>
            <a:hueOff val="9800891"/>
            <a:satOff val="-40777"/>
            <a:lumOff val="960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r>
            <a:rPr lang="en-ZA" sz="1100" i="1" kern="1200" dirty="0"/>
            <a:t>P. thermoglucosidasius</a:t>
          </a:r>
        </a:p>
      </dsp:txBody>
      <dsp:txXfrm>
        <a:off x="1250755" y="1765396"/>
        <a:ext cx="1171507" cy="1073882"/>
      </dsp:txXfrm>
    </dsp:sp>
  </dsp:spTree>
</dsp:drawing>
</file>

<file path=ppt/diagrams/layout1.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303743-5931-BB59-4ED4-E5985703F18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ZA"/>
          </a:p>
        </p:txBody>
      </p:sp>
      <p:sp>
        <p:nvSpPr>
          <p:cNvPr id="3" name="Subtitle 2">
            <a:extLst>
              <a:ext uri="{FF2B5EF4-FFF2-40B4-BE49-F238E27FC236}">
                <a16:creationId xmlns:a16="http://schemas.microsoft.com/office/drawing/2014/main" id="{2CA166AC-40FB-DED0-D1C9-0C66BCE7FBF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ZA"/>
          </a:p>
        </p:txBody>
      </p:sp>
      <p:sp>
        <p:nvSpPr>
          <p:cNvPr id="4" name="Date Placeholder 3">
            <a:extLst>
              <a:ext uri="{FF2B5EF4-FFF2-40B4-BE49-F238E27FC236}">
                <a16:creationId xmlns:a16="http://schemas.microsoft.com/office/drawing/2014/main" id="{1FE81FBA-3405-B468-7A98-AA58116BEFDA}"/>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5" name="Footer Placeholder 4">
            <a:extLst>
              <a:ext uri="{FF2B5EF4-FFF2-40B4-BE49-F238E27FC236}">
                <a16:creationId xmlns:a16="http://schemas.microsoft.com/office/drawing/2014/main" id="{BA599BFE-1E67-F841-D948-6413FC0FC6CE}"/>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2240FEEC-E2E6-E9CE-E64E-01C428F25B63}"/>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32116464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0F8941-5037-3575-448D-54263DAB6F53}"/>
              </a:ext>
            </a:extLst>
          </p:cNvPr>
          <p:cNvSpPr>
            <a:spLocks noGrp="1"/>
          </p:cNvSpPr>
          <p:nvPr>
            <p:ph type="title"/>
          </p:nvPr>
        </p:nvSpPr>
        <p:spPr/>
        <p:txBody>
          <a:bodyPr/>
          <a:lstStyle/>
          <a:p>
            <a:r>
              <a:rPr lang="en-US"/>
              <a:t>Click to edit Master title style</a:t>
            </a:r>
            <a:endParaRPr lang="en-ZA"/>
          </a:p>
        </p:txBody>
      </p:sp>
      <p:sp>
        <p:nvSpPr>
          <p:cNvPr id="3" name="Vertical Text Placeholder 2">
            <a:extLst>
              <a:ext uri="{FF2B5EF4-FFF2-40B4-BE49-F238E27FC236}">
                <a16:creationId xmlns:a16="http://schemas.microsoft.com/office/drawing/2014/main" id="{8730AE61-562B-AF55-DC8A-4AC482E5ED6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EDB2B082-CB94-B432-1FF5-5A6B9B45D6BA}"/>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5" name="Footer Placeholder 4">
            <a:extLst>
              <a:ext uri="{FF2B5EF4-FFF2-40B4-BE49-F238E27FC236}">
                <a16:creationId xmlns:a16="http://schemas.microsoft.com/office/drawing/2014/main" id="{8462D88B-97F8-CBDB-1677-5D8459C28989}"/>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EC58F5FD-DE34-9954-4638-2BF6375762B5}"/>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24039771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088CAC8-5705-CBCD-4A0B-EAE6B0707368}"/>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ZA"/>
          </a:p>
        </p:txBody>
      </p:sp>
      <p:sp>
        <p:nvSpPr>
          <p:cNvPr id="3" name="Vertical Text Placeholder 2">
            <a:extLst>
              <a:ext uri="{FF2B5EF4-FFF2-40B4-BE49-F238E27FC236}">
                <a16:creationId xmlns:a16="http://schemas.microsoft.com/office/drawing/2014/main" id="{411B103C-D017-A2D1-948B-4EC545509C0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366969ED-1F92-CE78-3088-0FDE6F517F83}"/>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5" name="Footer Placeholder 4">
            <a:extLst>
              <a:ext uri="{FF2B5EF4-FFF2-40B4-BE49-F238E27FC236}">
                <a16:creationId xmlns:a16="http://schemas.microsoft.com/office/drawing/2014/main" id="{29C31C79-9BB6-B0E2-363F-EDB7E5E01B97}"/>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521A9AB7-7B5E-2B66-43FF-26FF2CE16B31}"/>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2144315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F9D3B3-759F-9348-9CF0-AC96F9D4B422}"/>
              </a:ext>
            </a:extLst>
          </p:cNvPr>
          <p:cNvSpPr>
            <a:spLocks noGrp="1"/>
          </p:cNvSpPr>
          <p:nvPr>
            <p:ph type="title"/>
          </p:nvPr>
        </p:nvSpPr>
        <p:spPr/>
        <p:txBody>
          <a:bodyPr/>
          <a:lstStyle/>
          <a:p>
            <a:r>
              <a:rPr lang="en-US"/>
              <a:t>Click to edit Master title style</a:t>
            </a:r>
            <a:endParaRPr lang="en-ZA"/>
          </a:p>
        </p:txBody>
      </p:sp>
      <p:sp>
        <p:nvSpPr>
          <p:cNvPr id="3" name="Content Placeholder 2">
            <a:extLst>
              <a:ext uri="{FF2B5EF4-FFF2-40B4-BE49-F238E27FC236}">
                <a16:creationId xmlns:a16="http://schemas.microsoft.com/office/drawing/2014/main" id="{CDA95EA5-BCAA-CC10-05F2-BDBCC87011F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83108CF8-6B0E-2394-7D9C-68BF30AD0FEE}"/>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5" name="Footer Placeholder 4">
            <a:extLst>
              <a:ext uri="{FF2B5EF4-FFF2-40B4-BE49-F238E27FC236}">
                <a16:creationId xmlns:a16="http://schemas.microsoft.com/office/drawing/2014/main" id="{720BAA88-71B8-BD4E-6076-B480A19BCA34}"/>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85D0DCDF-8208-60B6-BAEC-0C5E811EECB7}"/>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14686803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82ACD4-7205-153D-6287-C18A4BA3B5B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ZA"/>
          </a:p>
        </p:txBody>
      </p:sp>
      <p:sp>
        <p:nvSpPr>
          <p:cNvPr id="3" name="Text Placeholder 2">
            <a:extLst>
              <a:ext uri="{FF2B5EF4-FFF2-40B4-BE49-F238E27FC236}">
                <a16:creationId xmlns:a16="http://schemas.microsoft.com/office/drawing/2014/main" id="{5259CC3B-6FAF-02E7-EEE3-CD5498A50D2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41E302D-45D4-31DB-0498-B1335728FE07}"/>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5" name="Footer Placeholder 4">
            <a:extLst>
              <a:ext uri="{FF2B5EF4-FFF2-40B4-BE49-F238E27FC236}">
                <a16:creationId xmlns:a16="http://schemas.microsoft.com/office/drawing/2014/main" id="{DBF8ABF7-8F06-74A7-8543-19FBCB262555}"/>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BD844CD6-FC8A-361D-9AF1-18C50E23DCD8}"/>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19862896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D95391-ABAD-AE6D-A562-006EA77F8454}"/>
              </a:ext>
            </a:extLst>
          </p:cNvPr>
          <p:cNvSpPr>
            <a:spLocks noGrp="1"/>
          </p:cNvSpPr>
          <p:nvPr>
            <p:ph type="title"/>
          </p:nvPr>
        </p:nvSpPr>
        <p:spPr/>
        <p:txBody>
          <a:bodyPr/>
          <a:lstStyle/>
          <a:p>
            <a:r>
              <a:rPr lang="en-US"/>
              <a:t>Click to edit Master title style</a:t>
            </a:r>
            <a:endParaRPr lang="en-ZA"/>
          </a:p>
        </p:txBody>
      </p:sp>
      <p:sp>
        <p:nvSpPr>
          <p:cNvPr id="3" name="Content Placeholder 2">
            <a:extLst>
              <a:ext uri="{FF2B5EF4-FFF2-40B4-BE49-F238E27FC236}">
                <a16:creationId xmlns:a16="http://schemas.microsoft.com/office/drawing/2014/main" id="{DF855777-6815-AC93-D5E0-BAE73EB3164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Content Placeholder 3">
            <a:extLst>
              <a:ext uri="{FF2B5EF4-FFF2-40B4-BE49-F238E27FC236}">
                <a16:creationId xmlns:a16="http://schemas.microsoft.com/office/drawing/2014/main" id="{64AEAFD3-9522-D57D-E006-86C96B1603B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5" name="Date Placeholder 4">
            <a:extLst>
              <a:ext uri="{FF2B5EF4-FFF2-40B4-BE49-F238E27FC236}">
                <a16:creationId xmlns:a16="http://schemas.microsoft.com/office/drawing/2014/main" id="{35FA4C91-2DD7-8C45-447F-09BDFD4406A7}"/>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6" name="Footer Placeholder 5">
            <a:extLst>
              <a:ext uri="{FF2B5EF4-FFF2-40B4-BE49-F238E27FC236}">
                <a16:creationId xmlns:a16="http://schemas.microsoft.com/office/drawing/2014/main" id="{47DA9378-7478-F053-C81A-51B2958CA4E9}"/>
              </a:ext>
            </a:extLst>
          </p:cNvPr>
          <p:cNvSpPr>
            <a:spLocks noGrp="1"/>
          </p:cNvSpPr>
          <p:nvPr>
            <p:ph type="ftr" sz="quarter" idx="11"/>
          </p:nvPr>
        </p:nvSpPr>
        <p:spPr/>
        <p:txBody>
          <a:bodyPr/>
          <a:lstStyle/>
          <a:p>
            <a:endParaRPr lang="en-ZA"/>
          </a:p>
        </p:txBody>
      </p:sp>
      <p:sp>
        <p:nvSpPr>
          <p:cNvPr id="7" name="Slide Number Placeholder 6">
            <a:extLst>
              <a:ext uri="{FF2B5EF4-FFF2-40B4-BE49-F238E27FC236}">
                <a16:creationId xmlns:a16="http://schemas.microsoft.com/office/drawing/2014/main" id="{264D08A3-16E2-BBB0-5249-F94EAEE52BC9}"/>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34141492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290E02-2290-838F-2EC3-B208D70A0A10}"/>
              </a:ext>
            </a:extLst>
          </p:cNvPr>
          <p:cNvSpPr>
            <a:spLocks noGrp="1"/>
          </p:cNvSpPr>
          <p:nvPr>
            <p:ph type="title"/>
          </p:nvPr>
        </p:nvSpPr>
        <p:spPr>
          <a:xfrm>
            <a:off x="839788" y="365125"/>
            <a:ext cx="10515600" cy="1325563"/>
          </a:xfrm>
        </p:spPr>
        <p:txBody>
          <a:bodyPr/>
          <a:lstStyle/>
          <a:p>
            <a:r>
              <a:rPr lang="en-US"/>
              <a:t>Click to edit Master title style</a:t>
            </a:r>
            <a:endParaRPr lang="en-ZA"/>
          </a:p>
        </p:txBody>
      </p:sp>
      <p:sp>
        <p:nvSpPr>
          <p:cNvPr id="3" name="Text Placeholder 2">
            <a:extLst>
              <a:ext uri="{FF2B5EF4-FFF2-40B4-BE49-F238E27FC236}">
                <a16:creationId xmlns:a16="http://schemas.microsoft.com/office/drawing/2014/main" id="{078B59FC-7165-F1F9-0F13-39838E8FB15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892C66C-7AB9-4D7A-48D1-534B4D21188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5" name="Text Placeholder 4">
            <a:extLst>
              <a:ext uri="{FF2B5EF4-FFF2-40B4-BE49-F238E27FC236}">
                <a16:creationId xmlns:a16="http://schemas.microsoft.com/office/drawing/2014/main" id="{E2BBBB40-D5A9-7A1C-41A4-534B6E35B08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0EABF5E-4344-05C1-BCA6-CD0085EB752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7" name="Date Placeholder 6">
            <a:extLst>
              <a:ext uri="{FF2B5EF4-FFF2-40B4-BE49-F238E27FC236}">
                <a16:creationId xmlns:a16="http://schemas.microsoft.com/office/drawing/2014/main" id="{F53111B5-2C2E-7C1A-6DFC-66B3348900C8}"/>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8" name="Footer Placeholder 7">
            <a:extLst>
              <a:ext uri="{FF2B5EF4-FFF2-40B4-BE49-F238E27FC236}">
                <a16:creationId xmlns:a16="http://schemas.microsoft.com/office/drawing/2014/main" id="{C349649E-D5F2-C55E-8453-FC77926FD7F9}"/>
              </a:ext>
            </a:extLst>
          </p:cNvPr>
          <p:cNvSpPr>
            <a:spLocks noGrp="1"/>
          </p:cNvSpPr>
          <p:nvPr>
            <p:ph type="ftr" sz="quarter" idx="11"/>
          </p:nvPr>
        </p:nvSpPr>
        <p:spPr/>
        <p:txBody>
          <a:bodyPr/>
          <a:lstStyle/>
          <a:p>
            <a:endParaRPr lang="en-ZA"/>
          </a:p>
        </p:txBody>
      </p:sp>
      <p:sp>
        <p:nvSpPr>
          <p:cNvPr id="9" name="Slide Number Placeholder 8">
            <a:extLst>
              <a:ext uri="{FF2B5EF4-FFF2-40B4-BE49-F238E27FC236}">
                <a16:creationId xmlns:a16="http://schemas.microsoft.com/office/drawing/2014/main" id="{85218FE6-1F94-45D1-F1AD-9D848E18C066}"/>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7331263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959DB8-B0B5-76AC-A1AF-3C6BF2075D53}"/>
              </a:ext>
            </a:extLst>
          </p:cNvPr>
          <p:cNvSpPr>
            <a:spLocks noGrp="1"/>
          </p:cNvSpPr>
          <p:nvPr>
            <p:ph type="title"/>
          </p:nvPr>
        </p:nvSpPr>
        <p:spPr/>
        <p:txBody>
          <a:bodyPr/>
          <a:lstStyle/>
          <a:p>
            <a:r>
              <a:rPr lang="en-US"/>
              <a:t>Click to edit Master title style</a:t>
            </a:r>
            <a:endParaRPr lang="en-ZA"/>
          </a:p>
        </p:txBody>
      </p:sp>
      <p:sp>
        <p:nvSpPr>
          <p:cNvPr id="3" name="Date Placeholder 2">
            <a:extLst>
              <a:ext uri="{FF2B5EF4-FFF2-40B4-BE49-F238E27FC236}">
                <a16:creationId xmlns:a16="http://schemas.microsoft.com/office/drawing/2014/main" id="{E7BE6089-D529-0BAE-80FD-F3657AAB2552}"/>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4" name="Footer Placeholder 3">
            <a:extLst>
              <a:ext uri="{FF2B5EF4-FFF2-40B4-BE49-F238E27FC236}">
                <a16:creationId xmlns:a16="http://schemas.microsoft.com/office/drawing/2014/main" id="{166FBCF4-DDBD-CBBB-AD8A-57D4A109B758}"/>
              </a:ext>
            </a:extLst>
          </p:cNvPr>
          <p:cNvSpPr>
            <a:spLocks noGrp="1"/>
          </p:cNvSpPr>
          <p:nvPr>
            <p:ph type="ftr" sz="quarter" idx="11"/>
          </p:nvPr>
        </p:nvSpPr>
        <p:spPr/>
        <p:txBody>
          <a:bodyPr/>
          <a:lstStyle/>
          <a:p>
            <a:endParaRPr lang="en-ZA"/>
          </a:p>
        </p:txBody>
      </p:sp>
      <p:sp>
        <p:nvSpPr>
          <p:cNvPr id="5" name="Slide Number Placeholder 4">
            <a:extLst>
              <a:ext uri="{FF2B5EF4-FFF2-40B4-BE49-F238E27FC236}">
                <a16:creationId xmlns:a16="http://schemas.microsoft.com/office/drawing/2014/main" id="{96F82E14-AD8B-949E-9464-FED178143E87}"/>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40656270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545C93B-D734-D884-177D-2C6ED2AD1822}"/>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3" name="Footer Placeholder 2">
            <a:extLst>
              <a:ext uri="{FF2B5EF4-FFF2-40B4-BE49-F238E27FC236}">
                <a16:creationId xmlns:a16="http://schemas.microsoft.com/office/drawing/2014/main" id="{7D625DFA-1C06-3C41-B8C1-53CD49F2A713}"/>
              </a:ext>
            </a:extLst>
          </p:cNvPr>
          <p:cNvSpPr>
            <a:spLocks noGrp="1"/>
          </p:cNvSpPr>
          <p:nvPr>
            <p:ph type="ftr" sz="quarter" idx="11"/>
          </p:nvPr>
        </p:nvSpPr>
        <p:spPr/>
        <p:txBody>
          <a:bodyPr/>
          <a:lstStyle/>
          <a:p>
            <a:endParaRPr lang="en-ZA"/>
          </a:p>
        </p:txBody>
      </p:sp>
      <p:sp>
        <p:nvSpPr>
          <p:cNvPr id="4" name="Slide Number Placeholder 3">
            <a:extLst>
              <a:ext uri="{FF2B5EF4-FFF2-40B4-BE49-F238E27FC236}">
                <a16:creationId xmlns:a16="http://schemas.microsoft.com/office/drawing/2014/main" id="{8F796048-10AC-5F77-F7B6-C01C907DF5B2}"/>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37348709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679E53-8E24-A5CC-6FFD-EFEBA3F8B41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ZA"/>
          </a:p>
        </p:txBody>
      </p:sp>
      <p:sp>
        <p:nvSpPr>
          <p:cNvPr id="3" name="Content Placeholder 2">
            <a:extLst>
              <a:ext uri="{FF2B5EF4-FFF2-40B4-BE49-F238E27FC236}">
                <a16:creationId xmlns:a16="http://schemas.microsoft.com/office/drawing/2014/main" id="{2E821C78-6C56-4DD9-33F1-3927A886292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Text Placeholder 3">
            <a:extLst>
              <a:ext uri="{FF2B5EF4-FFF2-40B4-BE49-F238E27FC236}">
                <a16:creationId xmlns:a16="http://schemas.microsoft.com/office/drawing/2014/main" id="{AE80BFBE-5528-B440-9636-071F63C620F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68C80D7-2132-F2EF-820C-5E20F54C1536}"/>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6" name="Footer Placeholder 5">
            <a:extLst>
              <a:ext uri="{FF2B5EF4-FFF2-40B4-BE49-F238E27FC236}">
                <a16:creationId xmlns:a16="http://schemas.microsoft.com/office/drawing/2014/main" id="{53AEC768-73FB-AAF9-D02A-5CAA9267169F}"/>
              </a:ext>
            </a:extLst>
          </p:cNvPr>
          <p:cNvSpPr>
            <a:spLocks noGrp="1"/>
          </p:cNvSpPr>
          <p:nvPr>
            <p:ph type="ftr" sz="quarter" idx="11"/>
          </p:nvPr>
        </p:nvSpPr>
        <p:spPr/>
        <p:txBody>
          <a:bodyPr/>
          <a:lstStyle/>
          <a:p>
            <a:endParaRPr lang="en-ZA"/>
          </a:p>
        </p:txBody>
      </p:sp>
      <p:sp>
        <p:nvSpPr>
          <p:cNvPr id="7" name="Slide Number Placeholder 6">
            <a:extLst>
              <a:ext uri="{FF2B5EF4-FFF2-40B4-BE49-F238E27FC236}">
                <a16:creationId xmlns:a16="http://schemas.microsoft.com/office/drawing/2014/main" id="{97B38A5B-ECFF-6E52-712B-EA21979A3691}"/>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37644123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735F66-19AA-73ED-62AF-674873D5AC4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ZA"/>
          </a:p>
        </p:txBody>
      </p:sp>
      <p:sp>
        <p:nvSpPr>
          <p:cNvPr id="3" name="Picture Placeholder 2">
            <a:extLst>
              <a:ext uri="{FF2B5EF4-FFF2-40B4-BE49-F238E27FC236}">
                <a16:creationId xmlns:a16="http://schemas.microsoft.com/office/drawing/2014/main" id="{481926D4-651A-9AE0-5FF8-1C340E48AC3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ZA"/>
          </a:p>
        </p:txBody>
      </p:sp>
      <p:sp>
        <p:nvSpPr>
          <p:cNvPr id="4" name="Text Placeholder 3">
            <a:extLst>
              <a:ext uri="{FF2B5EF4-FFF2-40B4-BE49-F238E27FC236}">
                <a16:creationId xmlns:a16="http://schemas.microsoft.com/office/drawing/2014/main" id="{E4F26662-1D01-83B7-2D35-254D7139D4F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BFF29D8-9971-6A81-2EA9-562D07C4C1E6}"/>
              </a:ext>
            </a:extLst>
          </p:cNvPr>
          <p:cNvSpPr>
            <a:spLocks noGrp="1"/>
          </p:cNvSpPr>
          <p:nvPr>
            <p:ph type="dt" sz="half" idx="10"/>
          </p:nvPr>
        </p:nvSpPr>
        <p:spPr/>
        <p:txBody>
          <a:bodyPr/>
          <a:lstStyle/>
          <a:p>
            <a:fld id="{C54AD0BE-9492-42F8-B595-813FE27B265D}" type="datetimeFigureOut">
              <a:rPr lang="en-ZA" smtClean="0"/>
              <a:t>2024/07/17</a:t>
            </a:fld>
            <a:endParaRPr lang="en-ZA"/>
          </a:p>
        </p:txBody>
      </p:sp>
      <p:sp>
        <p:nvSpPr>
          <p:cNvPr id="6" name="Footer Placeholder 5">
            <a:extLst>
              <a:ext uri="{FF2B5EF4-FFF2-40B4-BE49-F238E27FC236}">
                <a16:creationId xmlns:a16="http://schemas.microsoft.com/office/drawing/2014/main" id="{5D5EC02C-7ED5-EA8E-7A42-4CEFE31C23B0}"/>
              </a:ext>
            </a:extLst>
          </p:cNvPr>
          <p:cNvSpPr>
            <a:spLocks noGrp="1"/>
          </p:cNvSpPr>
          <p:nvPr>
            <p:ph type="ftr" sz="quarter" idx="11"/>
          </p:nvPr>
        </p:nvSpPr>
        <p:spPr/>
        <p:txBody>
          <a:bodyPr/>
          <a:lstStyle/>
          <a:p>
            <a:endParaRPr lang="en-ZA"/>
          </a:p>
        </p:txBody>
      </p:sp>
      <p:sp>
        <p:nvSpPr>
          <p:cNvPr id="7" name="Slide Number Placeholder 6">
            <a:extLst>
              <a:ext uri="{FF2B5EF4-FFF2-40B4-BE49-F238E27FC236}">
                <a16:creationId xmlns:a16="http://schemas.microsoft.com/office/drawing/2014/main" id="{2AED5F25-AC65-8B29-9FE0-62037593CFBC}"/>
              </a:ext>
            </a:extLst>
          </p:cNvPr>
          <p:cNvSpPr>
            <a:spLocks noGrp="1"/>
          </p:cNvSpPr>
          <p:nvPr>
            <p:ph type="sldNum" sz="quarter" idx="12"/>
          </p:nvPr>
        </p:nvSpPr>
        <p:spPr/>
        <p:txBody>
          <a:bodyPr/>
          <a:lstStyle/>
          <a:p>
            <a:fld id="{147720B8-4255-48F6-B11B-60A7BFA20906}" type="slidenum">
              <a:rPr lang="en-ZA" smtClean="0"/>
              <a:t>‹#›</a:t>
            </a:fld>
            <a:endParaRPr lang="en-ZA"/>
          </a:p>
        </p:txBody>
      </p:sp>
    </p:spTree>
    <p:extLst>
      <p:ext uri="{BB962C8B-B14F-4D97-AF65-F5344CB8AC3E}">
        <p14:creationId xmlns:p14="http://schemas.microsoft.com/office/powerpoint/2010/main" val="27784541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CEE12CE-2C26-BD73-E312-93AF0E2339F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ZA"/>
          </a:p>
        </p:txBody>
      </p:sp>
      <p:sp>
        <p:nvSpPr>
          <p:cNvPr id="3" name="Text Placeholder 2">
            <a:extLst>
              <a:ext uri="{FF2B5EF4-FFF2-40B4-BE49-F238E27FC236}">
                <a16:creationId xmlns:a16="http://schemas.microsoft.com/office/drawing/2014/main" id="{FF5E66AE-1A39-1B80-96B1-8E08F492D59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41E89080-75F5-B8F8-B600-F3C75CA1637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54AD0BE-9492-42F8-B595-813FE27B265D}" type="datetimeFigureOut">
              <a:rPr lang="en-ZA" smtClean="0"/>
              <a:t>2024/07/17</a:t>
            </a:fld>
            <a:endParaRPr lang="en-ZA"/>
          </a:p>
        </p:txBody>
      </p:sp>
      <p:sp>
        <p:nvSpPr>
          <p:cNvPr id="5" name="Footer Placeholder 4">
            <a:extLst>
              <a:ext uri="{FF2B5EF4-FFF2-40B4-BE49-F238E27FC236}">
                <a16:creationId xmlns:a16="http://schemas.microsoft.com/office/drawing/2014/main" id="{921EE1AC-A158-3DC7-2633-74F3E4D496A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ZA"/>
          </a:p>
        </p:txBody>
      </p:sp>
      <p:sp>
        <p:nvSpPr>
          <p:cNvPr id="6" name="Slide Number Placeholder 5">
            <a:extLst>
              <a:ext uri="{FF2B5EF4-FFF2-40B4-BE49-F238E27FC236}">
                <a16:creationId xmlns:a16="http://schemas.microsoft.com/office/drawing/2014/main" id="{7D3C7A89-A61E-D03D-64DF-1DE4C5A9E30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47720B8-4255-48F6-B11B-60A7BFA20906}" type="slidenum">
              <a:rPr lang="en-ZA" smtClean="0"/>
              <a:t>‹#›</a:t>
            </a:fld>
            <a:endParaRPr lang="en-ZA"/>
          </a:p>
        </p:txBody>
      </p:sp>
    </p:spTree>
    <p:extLst>
      <p:ext uri="{BB962C8B-B14F-4D97-AF65-F5344CB8AC3E}">
        <p14:creationId xmlns:p14="http://schemas.microsoft.com/office/powerpoint/2010/main" val="24913765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chart" Target="../charts/chart3.xml"/><Relationship Id="rId7" Type="http://schemas.openxmlformats.org/officeDocument/2006/relationships/diagramColors" Target="../diagrams/colors1.xml"/><Relationship Id="rId2" Type="http://schemas.openxmlformats.org/officeDocument/2006/relationships/chart" Target="../charts/chart2.xml"/><Relationship Id="rId1" Type="http://schemas.openxmlformats.org/officeDocument/2006/relationships/slideLayout" Target="../slideLayouts/slideLayout1.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16AA65D8-B625-32FB-C40C-6964A510CC69}"/>
              </a:ext>
            </a:extLst>
          </p:cNvPr>
          <p:cNvGraphicFramePr>
            <a:graphicFrameLocks/>
          </p:cNvGraphicFramePr>
          <p:nvPr>
            <p:extLst>
              <p:ext uri="{D42A27DB-BD31-4B8C-83A1-F6EECF244321}">
                <p14:modId xmlns:p14="http://schemas.microsoft.com/office/powerpoint/2010/main" val="1600687899"/>
              </p:ext>
            </p:extLst>
          </p:nvPr>
        </p:nvGraphicFramePr>
        <p:xfrm>
          <a:off x="1563965" y="111957"/>
          <a:ext cx="8705851" cy="3400425"/>
        </p:xfrm>
        <a:graphic>
          <a:graphicData uri="http://schemas.openxmlformats.org/drawingml/2006/chart">
            <c:chart xmlns:c="http://schemas.openxmlformats.org/drawingml/2006/chart" xmlns:r="http://schemas.openxmlformats.org/officeDocument/2006/relationships" r:id="rId2"/>
          </a:graphicData>
        </a:graphic>
      </p:graphicFrame>
      <p:pic>
        <p:nvPicPr>
          <p:cNvPr id="7" name="Picture 6">
            <a:extLst>
              <a:ext uri="{FF2B5EF4-FFF2-40B4-BE49-F238E27FC236}">
                <a16:creationId xmlns:a16="http://schemas.microsoft.com/office/drawing/2014/main" id="{9D0C7D3F-20D0-E547-9E60-C08C9F1E8E7F}"/>
              </a:ext>
            </a:extLst>
          </p:cNvPr>
          <p:cNvPicPr>
            <a:picLocks noChangeAspect="1"/>
          </p:cNvPicPr>
          <p:nvPr/>
        </p:nvPicPr>
        <p:blipFill>
          <a:blip r:embed="rId3"/>
          <a:stretch>
            <a:fillRect/>
          </a:stretch>
        </p:blipFill>
        <p:spPr>
          <a:xfrm>
            <a:off x="2453174" y="3752684"/>
            <a:ext cx="7097115" cy="1171739"/>
          </a:xfrm>
          <a:prstGeom prst="rect">
            <a:avLst/>
          </a:prstGeom>
        </p:spPr>
      </p:pic>
      <p:sp>
        <p:nvSpPr>
          <p:cNvPr id="8" name="TextBox 7">
            <a:extLst>
              <a:ext uri="{FF2B5EF4-FFF2-40B4-BE49-F238E27FC236}">
                <a16:creationId xmlns:a16="http://schemas.microsoft.com/office/drawing/2014/main" id="{14F1D5E0-1B5A-3B96-014E-2A37F457D341}"/>
              </a:ext>
            </a:extLst>
          </p:cNvPr>
          <p:cNvSpPr txBox="1"/>
          <p:nvPr/>
        </p:nvSpPr>
        <p:spPr>
          <a:xfrm>
            <a:off x="1648805" y="5271745"/>
            <a:ext cx="8705851" cy="1081771"/>
          </a:xfrm>
          <a:prstGeom prst="rect">
            <a:avLst/>
          </a:prstGeom>
          <a:noFill/>
        </p:spPr>
        <p:txBody>
          <a:bodyPr wrap="square">
            <a:spAutoFit/>
          </a:bodyPr>
          <a:lstStyle/>
          <a:p>
            <a:pPr algn="just">
              <a:lnSpc>
                <a:spcPct val="150000"/>
              </a:lnSpc>
              <a:spcAft>
                <a:spcPts val="800"/>
              </a:spcAft>
            </a:pPr>
            <a:r>
              <a:rPr lang="en-ZA" sz="1100" b="1" kern="100" dirty="0">
                <a:effectLst/>
                <a:ea typeface="Calibri" panose="020F0502020204030204" pitchFamily="34" charset="0"/>
                <a:cs typeface="Arial" panose="020B0604020202020204" pitchFamily="34" charset="0"/>
              </a:rPr>
              <a:t>Figure S1: COG supra-functional categorisation of proteins encoded on the genomes of </a:t>
            </a:r>
            <a:r>
              <a:rPr lang="en-ZA" sz="1100" b="1" i="1" kern="100" dirty="0" err="1">
                <a:effectLst/>
                <a:ea typeface="Calibri" panose="020F0502020204030204" pitchFamily="34" charset="0"/>
                <a:cs typeface="Arial" panose="020B0604020202020204" pitchFamily="34" charset="0"/>
              </a:rPr>
              <a:t>Parageobacillus</a:t>
            </a:r>
            <a:r>
              <a:rPr lang="en-ZA" sz="1100" b="1" i="1" kern="100" dirty="0">
                <a:effectLst/>
                <a:ea typeface="Calibri" panose="020F0502020204030204" pitchFamily="34" charset="0"/>
                <a:cs typeface="Arial" panose="020B0604020202020204" pitchFamily="34" charset="0"/>
              </a:rPr>
              <a:t>, </a:t>
            </a:r>
            <a:r>
              <a:rPr lang="en-ZA" sz="1100" b="1" i="1" kern="100" dirty="0" err="1">
                <a:effectLst/>
                <a:ea typeface="Calibri" panose="020F0502020204030204" pitchFamily="34" charset="0"/>
                <a:cs typeface="Arial" panose="020B0604020202020204" pitchFamily="34" charset="0"/>
              </a:rPr>
              <a:t>Saccharococcus</a:t>
            </a:r>
            <a:r>
              <a:rPr lang="en-ZA" sz="1100" b="1" kern="100" dirty="0">
                <a:effectLst/>
                <a:ea typeface="Calibri" panose="020F0502020204030204" pitchFamily="34" charset="0"/>
                <a:cs typeface="Arial" panose="020B0604020202020204" pitchFamily="34" charset="0"/>
              </a:rPr>
              <a:t> and </a:t>
            </a:r>
            <a:r>
              <a:rPr lang="en-ZA" sz="1100" b="1" i="1" kern="100" dirty="0">
                <a:effectLst/>
                <a:ea typeface="Calibri" panose="020F0502020204030204" pitchFamily="34" charset="0"/>
                <a:cs typeface="Arial" panose="020B0604020202020204" pitchFamily="34" charset="0"/>
              </a:rPr>
              <a:t>G. </a:t>
            </a:r>
            <a:r>
              <a:rPr lang="en-ZA" sz="1100" b="1" i="1" kern="100" dirty="0" err="1">
                <a:effectLst/>
                <a:ea typeface="Calibri" panose="020F0502020204030204" pitchFamily="34" charset="0"/>
                <a:cs typeface="Arial" panose="020B0604020202020204" pitchFamily="34" charset="0"/>
              </a:rPr>
              <a:t>thermodenitrificans</a:t>
            </a:r>
            <a:r>
              <a:rPr lang="en-ZA" sz="1100" b="1" i="1" kern="100" dirty="0">
                <a:effectLst/>
                <a:ea typeface="Calibri" panose="020F0502020204030204" pitchFamily="34" charset="0"/>
                <a:cs typeface="Arial" panose="020B0604020202020204" pitchFamily="34" charset="0"/>
              </a:rPr>
              <a:t> </a:t>
            </a:r>
            <a:r>
              <a:rPr lang="en-ZA" sz="1100" b="1" kern="100" dirty="0">
                <a:effectLst/>
                <a:ea typeface="Calibri" panose="020F0502020204030204" pitchFamily="34" charset="0"/>
                <a:cs typeface="Arial" panose="020B0604020202020204" pitchFamily="34" charset="0"/>
              </a:rPr>
              <a:t>DSM 465</a:t>
            </a:r>
            <a:r>
              <a:rPr lang="en-ZA" sz="1100" b="1" kern="100" baseline="30000" dirty="0">
                <a:effectLst/>
                <a:ea typeface="Calibri" panose="020F0502020204030204" pitchFamily="34" charset="0"/>
                <a:cs typeface="Arial" panose="020B0604020202020204" pitchFamily="34" charset="0"/>
              </a:rPr>
              <a:t>T</a:t>
            </a:r>
            <a:r>
              <a:rPr lang="en-ZA" sz="1100" b="1" kern="100" dirty="0">
                <a:effectLst/>
                <a:ea typeface="Calibri" panose="020F0502020204030204" pitchFamily="34" charset="0"/>
                <a:cs typeface="Arial" panose="020B0604020202020204" pitchFamily="34" charset="0"/>
              </a:rPr>
              <a:t>.  </a:t>
            </a:r>
            <a:r>
              <a:rPr lang="en-ZA" sz="1100" kern="100" dirty="0">
                <a:effectLst/>
                <a:ea typeface="Calibri" panose="020F0502020204030204" pitchFamily="34" charset="0"/>
                <a:cs typeface="Arial" panose="020B0604020202020204" pitchFamily="34" charset="0"/>
              </a:rPr>
              <a:t>The number of proteins assigned to COG functional categories are shown in brackets above each bar. The relative proportions for each COG category are given below the figure. Values &gt; mean + standard deviation are highlighted in green, while those &lt; mean – standard deviation are highlighted in red.</a:t>
            </a:r>
          </a:p>
        </p:txBody>
      </p:sp>
    </p:spTree>
    <p:extLst>
      <p:ext uri="{BB962C8B-B14F-4D97-AF65-F5344CB8AC3E}">
        <p14:creationId xmlns:p14="http://schemas.microsoft.com/office/powerpoint/2010/main" val="41796179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A83D902-2D6C-EF7E-F08D-31A783230707}"/>
            </a:ext>
          </a:extLst>
        </p:cNvPr>
        <p:cNvGrpSpPr/>
        <p:nvPr/>
      </p:nvGrpSpPr>
      <p:grpSpPr>
        <a:xfrm>
          <a:off x="0" y="0"/>
          <a:ext cx="0" cy="0"/>
          <a:chOff x="0" y="0"/>
          <a:chExt cx="0" cy="0"/>
        </a:xfrm>
      </p:grpSpPr>
      <p:sp>
        <p:nvSpPr>
          <p:cNvPr id="28" name="TextBox 27">
            <a:extLst>
              <a:ext uri="{FF2B5EF4-FFF2-40B4-BE49-F238E27FC236}">
                <a16:creationId xmlns:a16="http://schemas.microsoft.com/office/drawing/2014/main" id="{32CA27F4-C171-B408-88AA-E14D34E087BA}"/>
              </a:ext>
            </a:extLst>
          </p:cNvPr>
          <p:cNvSpPr txBox="1"/>
          <p:nvPr/>
        </p:nvSpPr>
        <p:spPr>
          <a:xfrm>
            <a:off x="4421572" y="3406610"/>
            <a:ext cx="471604" cy="415498"/>
          </a:xfrm>
          <a:prstGeom prst="rect">
            <a:avLst/>
          </a:prstGeom>
          <a:noFill/>
        </p:spPr>
        <p:txBody>
          <a:bodyPr wrap="none" rtlCol="0">
            <a:spAutoFit/>
          </a:bodyPr>
          <a:lstStyle/>
          <a:p>
            <a:pPr algn="ctr"/>
            <a:r>
              <a:rPr lang="en-US" sz="1050" dirty="0"/>
              <a:t>463 </a:t>
            </a:r>
          </a:p>
          <a:p>
            <a:pPr algn="ctr"/>
            <a:r>
              <a:rPr lang="en-US" sz="1050" dirty="0"/>
              <a:t>(263)</a:t>
            </a:r>
            <a:endParaRPr lang="en-ZA" sz="1050" dirty="0"/>
          </a:p>
        </p:txBody>
      </p:sp>
      <p:grpSp>
        <p:nvGrpSpPr>
          <p:cNvPr id="7" name="Group 6">
            <a:extLst>
              <a:ext uri="{FF2B5EF4-FFF2-40B4-BE49-F238E27FC236}">
                <a16:creationId xmlns:a16="http://schemas.microsoft.com/office/drawing/2014/main" id="{96AF5453-FBCB-4A11-1715-91A5625DE822}"/>
              </a:ext>
            </a:extLst>
          </p:cNvPr>
          <p:cNvGrpSpPr/>
          <p:nvPr/>
        </p:nvGrpSpPr>
        <p:grpSpPr>
          <a:xfrm>
            <a:off x="6568481" y="77634"/>
            <a:ext cx="4478949" cy="3839458"/>
            <a:chOff x="54234" y="2469660"/>
            <a:chExt cx="4391814" cy="4447115"/>
          </a:xfrm>
        </p:grpSpPr>
        <p:graphicFrame>
          <p:nvGraphicFramePr>
            <p:cNvPr id="13" name="Chart 12">
              <a:extLst>
                <a:ext uri="{FF2B5EF4-FFF2-40B4-BE49-F238E27FC236}">
                  <a16:creationId xmlns:a16="http://schemas.microsoft.com/office/drawing/2014/main" id="{E50F3628-2D0B-BB78-4282-E315909CEF7D}"/>
                </a:ext>
              </a:extLst>
            </p:cNvPr>
            <p:cNvGraphicFramePr>
              <a:graphicFrameLocks/>
            </p:cNvGraphicFramePr>
            <p:nvPr>
              <p:extLst>
                <p:ext uri="{D42A27DB-BD31-4B8C-83A1-F6EECF244321}">
                  <p14:modId xmlns:p14="http://schemas.microsoft.com/office/powerpoint/2010/main" val="1879247751"/>
                </p:ext>
              </p:extLst>
            </p:nvPr>
          </p:nvGraphicFramePr>
          <p:xfrm>
            <a:off x="54234" y="3064283"/>
            <a:ext cx="4391814" cy="3852492"/>
          </p:xfrm>
          <a:graphic>
            <a:graphicData uri="http://schemas.openxmlformats.org/drawingml/2006/chart">
              <c:chart xmlns:c="http://schemas.openxmlformats.org/drawingml/2006/chart" xmlns:r="http://schemas.openxmlformats.org/officeDocument/2006/relationships" r:id="rId2"/>
            </a:graphicData>
          </a:graphic>
        </p:graphicFrame>
        <p:sp>
          <p:nvSpPr>
            <p:cNvPr id="15" name="TextBox 14">
              <a:extLst>
                <a:ext uri="{FF2B5EF4-FFF2-40B4-BE49-F238E27FC236}">
                  <a16:creationId xmlns:a16="http://schemas.microsoft.com/office/drawing/2014/main" id="{B9E8F151-187A-997F-ED5B-9872050A6A27}"/>
                </a:ext>
              </a:extLst>
            </p:cNvPr>
            <p:cNvSpPr txBox="1"/>
            <p:nvPr/>
          </p:nvSpPr>
          <p:spPr>
            <a:xfrm>
              <a:off x="506713" y="2669715"/>
              <a:ext cx="540533" cy="415498"/>
            </a:xfrm>
            <a:prstGeom prst="rect">
              <a:avLst/>
            </a:prstGeom>
            <a:noFill/>
          </p:spPr>
          <p:txBody>
            <a:bodyPr wrap="none" rtlCol="0">
              <a:spAutoFit/>
            </a:bodyPr>
            <a:lstStyle/>
            <a:p>
              <a:pPr algn="ctr"/>
              <a:r>
                <a:rPr lang="en-US" sz="1050" dirty="0"/>
                <a:t>2948 </a:t>
              </a:r>
            </a:p>
            <a:p>
              <a:pPr algn="ctr"/>
              <a:r>
                <a:rPr lang="en-US" sz="1050" dirty="0"/>
                <a:t>(2010)</a:t>
              </a:r>
              <a:endParaRPr lang="en-ZA" sz="1050" dirty="0"/>
            </a:p>
          </p:txBody>
        </p:sp>
        <p:sp>
          <p:nvSpPr>
            <p:cNvPr id="16" name="TextBox 15">
              <a:extLst>
                <a:ext uri="{FF2B5EF4-FFF2-40B4-BE49-F238E27FC236}">
                  <a16:creationId xmlns:a16="http://schemas.microsoft.com/office/drawing/2014/main" id="{A474DE2F-078B-3D88-55C7-F17E9D910855}"/>
                </a:ext>
              </a:extLst>
            </p:cNvPr>
            <p:cNvSpPr txBox="1"/>
            <p:nvPr/>
          </p:nvSpPr>
          <p:spPr>
            <a:xfrm>
              <a:off x="1057337" y="2671200"/>
              <a:ext cx="490839" cy="415498"/>
            </a:xfrm>
            <a:prstGeom prst="rect">
              <a:avLst/>
            </a:prstGeom>
            <a:noFill/>
          </p:spPr>
          <p:txBody>
            <a:bodyPr wrap="none" rtlCol="0">
              <a:spAutoFit/>
            </a:bodyPr>
            <a:lstStyle/>
            <a:p>
              <a:pPr algn="ctr"/>
              <a:r>
                <a:rPr lang="en-US" sz="1050" dirty="0"/>
                <a:t>1211 </a:t>
              </a:r>
            </a:p>
            <a:p>
              <a:pPr algn="ctr"/>
              <a:r>
                <a:rPr lang="en-US" sz="1050" dirty="0"/>
                <a:t>(366)</a:t>
              </a:r>
              <a:endParaRPr lang="en-ZA" sz="1050" dirty="0"/>
            </a:p>
          </p:txBody>
        </p:sp>
        <p:sp>
          <p:nvSpPr>
            <p:cNvPr id="17" name="TextBox 16">
              <a:extLst>
                <a:ext uri="{FF2B5EF4-FFF2-40B4-BE49-F238E27FC236}">
                  <a16:creationId xmlns:a16="http://schemas.microsoft.com/office/drawing/2014/main" id="{324B65CE-F690-278E-C482-0553FF5AFCFD}"/>
                </a:ext>
              </a:extLst>
            </p:cNvPr>
            <p:cNvSpPr txBox="1"/>
            <p:nvPr/>
          </p:nvSpPr>
          <p:spPr>
            <a:xfrm>
              <a:off x="1614346" y="2671200"/>
              <a:ext cx="490840" cy="415498"/>
            </a:xfrm>
            <a:prstGeom prst="rect">
              <a:avLst/>
            </a:prstGeom>
            <a:noFill/>
          </p:spPr>
          <p:txBody>
            <a:bodyPr wrap="none" rtlCol="0">
              <a:spAutoFit/>
            </a:bodyPr>
            <a:lstStyle/>
            <a:p>
              <a:pPr algn="ctr"/>
              <a:r>
                <a:rPr lang="en-US" sz="1050" dirty="0"/>
                <a:t>1529 </a:t>
              </a:r>
            </a:p>
            <a:p>
              <a:pPr algn="ctr"/>
              <a:r>
                <a:rPr lang="en-US" sz="1050" dirty="0"/>
                <a:t>(547)</a:t>
              </a:r>
              <a:endParaRPr lang="en-ZA" sz="1050" dirty="0"/>
            </a:p>
          </p:txBody>
        </p:sp>
        <p:sp>
          <p:nvSpPr>
            <p:cNvPr id="18" name="TextBox 17">
              <a:extLst>
                <a:ext uri="{FF2B5EF4-FFF2-40B4-BE49-F238E27FC236}">
                  <a16:creationId xmlns:a16="http://schemas.microsoft.com/office/drawing/2014/main" id="{26931DEF-D5C8-F99F-2190-D4121FA9E969}"/>
                </a:ext>
              </a:extLst>
            </p:cNvPr>
            <p:cNvSpPr txBox="1"/>
            <p:nvPr/>
          </p:nvSpPr>
          <p:spPr>
            <a:xfrm>
              <a:off x="2171355" y="2671200"/>
              <a:ext cx="490840" cy="415498"/>
            </a:xfrm>
            <a:prstGeom prst="rect">
              <a:avLst/>
            </a:prstGeom>
            <a:noFill/>
          </p:spPr>
          <p:txBody>
            <a:bodyPr wrap="none" rtlCol="0">
              <a:spAutoFit/>
            </a:bodyPr>
            <a:lstStyle/>
            <a:p>
              <a:pPr algn="ctr"/>
              <a:r>
                <a:rPr lang="en-US" sz="1050" dirty="0"/>
                <a:t>1229 </a:t>
              </a:r>
            </a:p>
            <a:p>
              <a:pPr algn="ctr"/>
              <a:r>
                <a:rPr lang="en-US" sz="1050" dirty="0"/>
                <a:t>(495)</a:t>
              </a:r>
              <a:endParaRPr lang="en-ZA" sz="1050" dirty="0"/>
            </a:p>
          </p:txBody>
        </p:sp>
        <p:sp>
          <p:nvSpPr>
            <p:cNvPr id="19" name="TextBox 18">
              <a:extLst>
                <a:ext uri="{FF2B5EF4-FFF2-40B4-BE49-F238E27FC236}">
                  <a16:creationId xmlns:a16="http://schemas.microsoft.com/office/drawing/2014/main" id="{4EE63227-993C-BA8E-2A14-1B0D6159E052}"/>
                </a:ext>
              </a:extLst>
            </p:cNvPr>
            <p:cNvSpPr txBox="1"/>
            <p:nvPr/>
          </p:nvSpPr>
          <p:spPr>
            <a:xfrm>
              <a:off x="2720311" y="2671200"/>
              <a:ext cx="471604" cy="415498"/>
            </a:xfrm>
            <a:prstGeom prst="rect">
              <a:avLst/>
            </a:prstGeom>
            <a:noFill/>
          </p:spPr>
          <p:txBody>
            <a:bodyPr wrap="none" rtlCol="0">
              <a:spAutoFit/>
            </a:bodyPr>
            <a:lstStyle/>
            <a:p>
              <a:pPr algn="ctr"/>
              <a:r>
                <a:rPr lang="en-US" sz="1050" dirty="0"/>
                <a:t>502 </a:t>
              </a:r>
            </a:p>
            <a:p>
              <a:pPr algn="ctr"/>
              <a:r>
                <a:rPr lang="en-US" sz="1050" dirty="0"/>
                <a:t>(260)</a:t>
              </a:r>
              <a:endParaRPr lang="en-ZA" sz="1050" dirty="0"/>
            </a:p>
          </p:txBody>
        </p:sp>
        <p:sp>
          <p:nvSpPr>
            <p:cNvPr id="20" name="TextBox 19">
              <a:extLst>
                <a:ext uri="{FF2B5EF4-FFF2-40B4-BE49-F238E27FC236}">
                  <a16:creationId xmlns:a16="http://schemas.microsoft.com/office/drawing/2014/main" id="{35FBCAEE-CBD9-828D-C19C-F29F07FE8826}"/>
                </a:ext>
              </a:extLst>
            </p:cNvPr>
            <p:cNvSpPr txBox="1"/>
            <p:nvPr/>
          </p:nvSpPr>
          <p:spPr>
            <a:xfrm>
              <a:off x="3264089" y="2671200"/>
              <a:ext cx="471604" cy="415498"/>
            </a:xfrm>
            <a:prstGeom prst="rect">
              <a:avLst/>
            </a:prstGeom>
            <a:noFill/>
          </p:spPr>
          <p:txBody>
            <a:bodyPr wrap="none" rtlCol="0">
              <a:spAutoFit/>
            </a:bodyPr>
            <a:lstStyle/>
            <a:p>
              <a:pPr algn="ctr"/>
              <a:r>
                <a:rPr lang="en-US" sz="1050" dirty="0"/>
                <a:t>396 </a:t>
              </a:r>
            </a:p>
            <a:p>
              <a:pPr algn="ctr"/>
              <a:r>
                <a:rPr lang="en-US" sz="1050" dirty="0"/>
                <a:t>(263)</a:t>
              </a:r>
              <a:endParaRPr lang="en-ZA" sz="1050" dirty="0"/>
            </a:p>
          </p:txBody>
        </p:sp>
        <p:sp>
          <p:nvSpPr>
            <p:cNvPr id="21" name="TextBox 20">
              <a:extLst>
                <a:ext uri="{FF2B5EF4-FFF2-40B4-BE49-F238E27FC236}">
                  <a16:creationId xmlns:a16="http://schemas.microsoft.com/office/drawing/2014/main" id="{22D57FB0-CB33-F575-8E6D-9EB61B5E2B9C}"/>
                </a:ext>
              </a:extLst>
            </p:cNvPr>
            <p:cNvSpPr txBox="1"/>
            <p:nvPr/>
          </p:nvSpPr>
          <p:spPr>
            <a:xfrm>
              <a:off x="3802571" y="2671200"/>
              <a:ext cx="471604" cy="415498"/>
            </a:xfrm>
            <a:prstGeom prst="rect">
              <a:avLst/>
            </a:prstGeom>
            <a:noFill/>
          </p:spPr>
          <p:txBody>
            <a:bodyPr wrap="none" rtlCol="0">
              <a:spAutoFit/>
            </a:bodyPr>
            <a:lstStyle/>
            <a:p>
              <a:pPr algn="ctr"/>
              <a:r>
                <a:rPr lang="en-US" sz="1050" dirty="0"/>
                <a:t>463 </a:t>
              </a:r>
            </a:p>
            <a:p>
              <a:pPr algn="ctr"/>
              <a:r>
                <a:rPr lang="en-US" sz="1050" dirty="0"/>
                <a:t>(263)</a:t>
              </a:r>
              <a:endParaRPr lang="en-ZA" sz="1050" dirty="0"/>
            </a:p>
          </p:txBody>
        </p:sp>
        <p:sp>
          <p:nvSpPr>
            <p:cNvPr id="30" name="TextBox 29">
              <a:extLst>
                <a:ext uri="{FF2B5EF4-FFF2-40B4-BE49-F238E27FC236}">
                  <a16:creationId xmlns:a16="http://schemas.microsoft.com/office/drawing/2014/main" id="{8453CDFD-9EC2-8CA7-E731-0456BB9BEBAC}"/>
                </a:ext>
              </a:extLst>
            </p:cNvPr>
            <p:cNvSpPr txBox="1"/>
            <p:nvPr/>
          </p:nvSpPr>
          <p:spPr>
            <a:xfrm>
              <a:off x="92455" y="2469660"/>
              <a:ext cx="324128" cy="369332"/>
            </a:xfrm>
            <a:prstGeom prst="rect">
              <a:avLst/>
            </a:prstGeom>
            <a:noFill/>
          </p:spPr>
          <p:txBody>
            <a:bodyPr wrap="none" rtlCol="0">
              <a:spAutoFit/>
            </a:bodyPr>
            <a:lstStyle/>
            <a:p>
              <a:r>
                <a:rPr lang="en-ZA" b="1" dirty="0"/>
                <a:t>B</a:t>
              </a:r>
            </a:p>
          </p:txBody>
        </p:sp>
      </p:grpSp>
      <p:graphicFrame>
        <p:nvGraphicFramePr>
          <p:cNvPr id="14" name="Chart 13">
            <a:extLst>
              <a:ext uri="{FF2B5EF4-FFF2-40B4-BE49-F238E27FC236}">
                <a16:creationId xmlns:a16="http://schemas.microsoft.com/office/drawing/2014/main" id="{7A7B3697-DEEE-A8B6-BADC-BF290926C11B}"/>
              </a:ext>
            </a:extLst>
          </p:cNvPr>
          <p:cNvGraphicFramePr>
            <a:graphicFrameLocks/>
          </p:cNvGraphicFramePr>
          <p:nvPr>
            <p:extLst>
              <p:ext uri="{D42A27DB-BD31-4B8C-83A1-F6EECF244321}">
                <p14:modId xmlns:p14="http://schemas.microsoft.com/office/powerpoint/2010/main" val="466674459"/>
              </p:ext>
            </p:extLst>
          </p:nvPr>
        </p:nvGraphicFramePr>
        <p:xfrm>
          <a:off x="723090" y="3724576"/>
          <a:ext cx="4391814" cy="3106788"/>
        </p:xfrm>
        <a:graphic>
          <a:graphicData uri="http://schemas.openxmlformats.org/drawingml/2006/chart">
            <c:chart xmlns:c="http://schemas.openxmlformats.org/drawingml/2006/chart" xmlns:r="http://schemas.openxmlformats.org/officeDocument/2006/relationships" r:id="rId3"/>
          </a:graphicData>
        </a:graphic>
      </p:graphicFrame>
      <p:sp>
        <p:nvSpPr>
          <p:cNvPr id="22" name="TextBox 21">
            <a:extLst>
              <a:ext uri="{FF2B5EF4-FFF2-40B4-BE49-F238E27FC236}">
                <a16:creationId xmlns:a16="http://schemas.microsoft.com/office/drawing/2014/main" id="{7D0374B6-47CA-0405-37CE-4CE22DB02A84}"/>
              </a:ext>
            </a:extLst>
          </p:cNvPr>
          <p:cNvSpPr txBox="1"/>
          <p:nvPr/>
        </p:nvSpPr>
        <p:spPr>
          <a:xfrm>
            <a:off x="1144570" y="3405125"/>
            <a:ext cx="540533" cy="415498"/>
          </a:xfrm>
          <a:prstGeom prst="rect">
            <a:avLst/>
          </a:prstGeom>
          <a:noFill/>
        </p:spPr>
        <p:txBody>
          <a:bodyPr wrap="none" rtlCol="0">
            <a:spAutoFit/>
          </a:bodyPr>
          <a:lstStyle/>
          <a:p>
            <a:pPr algn="ctr"/>
            <a:r>
              <a:rPr lang="en-US" sz="1050" dirty="0"/>
              <a:t>2948 </a:t>
            </a:r>
          </a:p>
          <a:p>
            <a:pPr algn="ctr"/>
            <a:r>
              <a:rPr lang="en-US" sz="1050" dirty="0"/>
              <a:t>(2010)</a:t>
            </a:r>
            <a:endParaRPr lang="en-ZA" sz="1050" dirty="0"/>
          </a:p>
        </p:txBody>
      </p:sp>
      <p:sp>
        <p:nvSpPr>
          <p:cNvPr id="23" name="TextBox 22">
            <a:extLst>
              <a:ext uri="{FF2B5EF4-FFF2-40B4-BE49-F238E27FC236}">
                <a16:creationId xmlns:a16="http://schemas.microsoft.com/office/drawing/2014/main" id="{F7AC78BA-F4D2-60BF-6970-97DC04731EF4}"/>
              </a:ext>
            </a:extLst>
          </p:cNvPr>
          <p:cNvSpPr txBox="1"/>
          <p:nvPr/>
        </p:nvSpPr>
        <p:spPr>
          <a:xfrm>
            <a:off x="1695194" y="3406610"/>
            <a:ext cx="490839" cy="415498"/>
          </a:xfrm>
          <a:prstGeom prst="rect">
            <a:avLst/>
          </a:prstGeom>
          <a:noFill/>
        </p:spPr>
        <p:txBody>
          <a:bodyPr wrap="none" rtlCol="0">
            <a:spAutoFit/>
          </a:bodyPr>
          <a:lstStyle/>
          <a:p>
            <a:pPr algn="ctr"/>
            <a:r>
              <a:rPr lang="en-US" sz="1050" dirty="0"/>
              <a:t>1211 </a:t>
            </a:r>
          </a:p>
          <a:p>
            <a:pPr algn="ctr"/>
            <a:r>
              <a:rPr lang="en-US" sz="1050" dirty="0"/>
              <a:t>(366)</a:t>
            </a:r>
            <a:endParaRPr lang="en-ZA" sz="1050" dirty="0"/>
          </a:p>
        </p:txBody>
      </p:sp>
      <p:sp>
        <p:nvSpPr>
          <p:cNvPr id="24" name="TextBox 23">
            <a:extLst>
              <a:ext uri="{FF2B5EF4-FFF2-40B4-BE49-F238E27FC236}">
                <a16:creationId xmlns:a16="http://schemas.microsoft.com/office/drawing/2014/main" id="{3B665AF2-7D63-C32A-B8F6-16DF191E9B78}"/>
              </a:ext>
            </a:extLst>
          </p:cNvPr>
          <p:cNvSpPr txBox="1"/>
          <p:nvPr/>
        </p:nvSpPr>
        <p:spPr>
          <a:xfrm>
            <a:off x="2252203" y="3406610"/>
            <a:ext cx="490840" cy="415498"/>
          </a:xfrm>
          <a:prstGeom prst="rect">
            <a:avLst/>
          </a:prstGeom>
          <a:noFill/>
        </p:spPr>
        <p:txBody>
          <a:bodyPr wrap="none" rtlCol="0">
            <a:spAutoFit/>
          </a:bodyPr>
          <a:lstStyle/>
          <a:p>
            <a:pPr algn="ctr"/>
            <a:r>
              <a:rPr lang="en-US" sz="1050" dirty="0"/>
              <a:t>1529 </a:t>
            </a:r>
          </a:p>
          <a:p>
            <a:pPr algn="ctr"/>
            <a:r>
              <a:rPr lang="en-US" sz="1050" dirty="0"/>
              <a:t>(547)</a:t>
            </a:r>
            <a:endParaRPr lang="en-ZA" sz="1050" dirty="0"/>
          </a:p>
        </p:txBody>
      </p:sp>
      <p:sp>
        <p:nvSpPr>
          <p:cNvPr id="25" name="TextBox 24">
            <a:extLst>
              <a:ext uri="{FF2B5EF4-FFF2-40B4-BE49-F238E27FC236}">
                <a16:creationId xmlns:a16="http://schemas.microsoft.com/office/drawing/2014/main" id="{415A3DF1-B0BC-A917-C20B-5A08C0E10FE7}"/>
              </a:ext>
            </a:extLst>
          </p:cNvPr>
          <p:cNvSpPr txBox="1"/>
          <p:nvPr/>
        </p:nvSpPr>
        <p:spPr>
          <a:xfrm>
            <a:off x="2809212" y="3406610"/>
            <a:ext cx="490840" cy="415498"/>
          </a:xfrm>
          <a:prstGeom prst="rect">
            <a:avLst/>
          </a:prstGeom>
          <a:noFill/>
        </p:spPr>
        <p:txBody>
          <a:bodyPr wrap="none" rtlCol="0">
            <a:spAutoFit/>
          </a:bodyPr>
          <a:lstStyle/>
          <a:p>
            <a:pPr algn="ctr"/>
            <a:r>
              <a:rPr lang="en-US" sz="1050" dirty="0"/>
              <a:t>1229 </a:t>
            </a:r>
          </a:p>
          <a:p>
            <a:pPr algn="ctr"/>
            <a:r>
              <a:rPr lang="en-US" sz="1050" dirty="0"/>
              <a:t>(495)</a:t>
            </a:r>
            <a:endParaRPr lang="en-ZA" sz="1050" dirty="0"/>
          </a:p>
        </p:txBody>
      </p:sp>
      <p:sp>
        <p:nvSpPr>
          <p:cNvPr id="26" name="TextBox 25">
            <a:extLst>
              <a:ext uri="{FF2B5EF4-FFF2-40B4-BE49-F238E27FC236}">
                <a16:creationId xmlns:a16="http://schemas.microsoft.com/office/drawing/2014/main" id="{EF7E7C76-E1BE-A6CF-A8BA-520A726B2178}"/>
              </a:ext>
            </a:extLst>
          </p:cNvPr>
          <p:cNvSpPr txBox="1"/>
          <p:nvPr/>
        </p:nvSpPr>
        <p:spPr>
          <a:xfrm>
            <a:off x="3358168" y="3406610"/>
            <a:ext cx="471604" cy="415498"/>
          </a:xfrm>
          <a:prstGeom prst="rect">
            <a:avLst/>
          </a:prstGeom>
          <a:noFill/>
        </p:spPr>
        <p:txBody>
          <a:bodyPr wrap="none" rtlCol="0">
            <a:spAutoFit/>
          </a:bodyPr>
          <a:lstStyle/>
          <a:p>
            <a:pPr algn="ctr"/>
            <a:r>
              <a:rPr lang="en-US" sz="1050" dirty="0"/>
              <a:t>502 </a:t>
            </a:r>
          </a:p>
          <a:p>
            <a:pPr algn="ctr"/>
            <a:r>
              <a:rPr lang="en-US" sz="1050" dirty="0"/>
              <a:t>(260)</a:t>
            </a:r>
            <a:endParaRPr lang="en-ZA" sz="1050" dirty="0"/>
          </a:p>
        </p:txBody>
      </p:sp>
      <p:sp>
        <p:nvSpPr>
          <p:cNvPr id="27" name="TextBox 26">
            <a:extLst>
              <a:ext uri="{FF2B5EF4-FFF2-40B4-BE49-F238E27FC236}">
                <a16:creationId xmlns:a16="http://schemas.microsoft.com/office/drawing/2014/main" id="{0B1FD582-C1AE-575B-15C9-3B4B0131F283}"/>
              </a:ext>
            </a:extLst>
          </p:cNvPr>
          <p:cNvSpPr txBox="1"/>
          <p:nvPr/>
        </p:nvSpPr>
        <p:spPr>
          <a:xfrm>
            <a:off x="3901946" y="3406610"/>
            <a:ext cx="471604" cy="415498"/>
          </a:xfrm>
          <a:prstGeom prst="rect">
            <a:avLst/>
          </a:prstGeom>
          <a:noFill/>
        </p:spPr>
        <p:txBody>
          <a:bodyPr wrap="none" rtlCol="0">
            <a:spAutoFit/>
          </a:bodyPr>
          <a:lstStyle/>
          <a:p>
            <a:pPr algn="ctr"/>
            <a:r>
              <a:rPr lang="en-US" sz="1050" dirty="0"/>
              <a:t>396 </a:t>
            </a:r>
          </a:p>
          <a:p>
            <a:pPr algn="ctr"/>
            <a:r>
              <a:rPr lang="en-US" sz="1050" dirty="0"/>
              <a:t>(263)</a:t>
            </a:r>
            <a:endParaRPr lang="en-ZA" sz="1050" dirty="0"/>
          </a:p>
        </p:txBody>
      </p:sp>
      <p:grpSp>
        <p:nvGrpSpPr>
          <p:cNvPr id="4" name="Group 3">
            <a:extLst>
              <a:ext uri="{FF2B5EF4-FFF2-40B4-BE49-F238E27FC236}">
                <a16:creationId xmlns:a16="http://schemas.microsoft.com/office/drawing/2014/main" id="{A5926870-E766-4165-2D17-07A146DA36EE}"/>
              </a:ext>
            </a:extLst>
          </p:cNvPr>
          <p:cNvGrpSpPr/>
          <p:nvPr/>
        </p:nvGrpSpPr>
        <p:grpSpPr>
          <a:xfrm>
            <a:off x="-259502" y="0"/>
            <a:ext cx="5495364" cy="3623520"/>
            <a:chOff x="3238389" y="-4484"/>
            <a:chExt cx="5495364" cy="3623520"/>
          </a:xfrm>
        </p:grpSpPr>
        <p:graphicFrame>
          <p:nvGraphicFramePr>
            <p:cNvPr id="3" name="Diagram 2">
              <a:extLst>
                <a:ext uri="{FF2B5EF4-FFF2-40B4-BE49-F238E27FC236}">
                  <a16:creationId xmlns:a16="http://schemas.microsoft.com/office/drawing/2014/main" id="{42A7F08F-3199-C3D3-04BB-D94F183DCCF2}"/>
                </a:ext>
              </a:extLst>
            </p:cNvPr>
            <p:cNvGraphicFramePr/>
            <p:nvPr>
              <p:extLst>
                <p:ext uri="{D42A27DB-BD31-4B8C-83A1-F6EECF244321}">
                  <p14:modId xmlns:p14="http://schemas.microsoft.com/office/powerpoint/2010/main" val="4193759542"/>
                </p:ext>
              </p:extLst>
            </p:nvPr>
          </p:nvGraphicFramePr>
          <p:xfrm>
            <a:off x="3238389" y="-4484"/>
            <a:ext cx="5495364" cy="3254188"/>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5" name="TextBox 4">
              <a:extLst>
                <a:ext uri="{FF2B5EF4-FFF2-40B4-BE49-F238E27FC236}">
                  <a16:creationId xmlns:a16="http://schemas.microsoft.com/office/drawing/2014/main" id="{B14A0C39-F687-080F-466E-374EA93B47DE}"/>
                </a:ext>
              </a:extLst>
            </p:cNvPr>
            <p:cNvSpPr txBox="1"/>
            <p:nvPr/>
          </p:nvSpPr>
          <p:spPr>
            <a:xfrm>
              <a:off x="5760053" y="836581"/>
              <a:ext cx="562193" cy="369332"/>
            </a:xfrm>
            <a:prstGeom prst="rect">
              <a:avLst/>
            </a:prstGeom>
            <a:noFill/>
          </p:spPr>
          <p:txBody>
            <a:bodyPr wrap="square" rtlCol="0">
              <a:spAutoFit/>
            </a:bodyPr>
            <a:lstStyle/>
            <a:p>
              <a:pPr algn="ctr"/>
              <a:r>
                <a:rPr lang="en-ZA" sz="900" dirty="0">
                  <a:solidFill>
                    <a:srgbClr val="FF0000"/>
                  </a:solidFill>
                </a:rPr>
                <a:t>141</a:t>
              </a:r>
              <a:br>
                <a:rPr lang="en-ZA" sz="900" dirty="0"/>
              </a:br>
              <a:r>
                <a:rPr lang="en-ZA" sz="900" dirty="0"/>
                <a:t>(1229)</a:t>
              </a:r>
            </a:p>
          </p:txBody>
        </p:sp>
        <p:sp>
          <p:nvSpPr>
            <p:cNvPr id="6" name="TextBox 5">
              <a:extLst>
                <a:ext uri="{FF2B5EF4-FFF2-40B4-BE49-F238E27FC236}">
                  <a16:creationId xmlns:a16="http://schemas.microsoft.com/office/drawing/2014/main" id="{4B0A1773-7873-FAFD-1090-277466B2F998}"/>
                </a:ext>
              </a:extLst>
            </p:cNvPr>
            <p:cNvSpPr txBox="1"/>
            <p:nvPr/>
          </p:nvSpPr>
          <p:spPr>
            <a:xfrm>
              <a:off x="6798268" y="2486086"/>
              <a:ext cx="558181" cy="400110"/>
            </a:xfrm>
            <a:prstGeom prst="rect">
              <a:avLst/>
            </a:prstGeom>
            <a:noFill/>
          </p:spPr>
          <p:txBody>
            <a:bodyPr wrap="square" rtlCol="0">
              <a:spAutoFit/>
            </a:bodyPr>
            <a:lstStyle/>
            <a:p>
              <a:pPr algn="ctr"/>
              <a:r>
                <a:rPr lang="en-ZA" sz="1000" dirty="0">
                  <a:solidFill>
                    <a:srgbClr val="FF0000"/>
                  </a:solidFill>
                </a:rPr>
                <a:t>42</a:t>
              </a:r>
              <a:br>
                <a:rPr lang="en-ZA" sz="1000" dirty="0"/>
              </a:br>
              <a:r>
                <a:rPr lang="en-ZA" sz="1000" dirty="0"/>
                <a:t>(1211)</a:t>
              </a:r>
            </a:p>
          </p:txBody>
        </p:sp>
        <p:sp>
          <p:nvSpPr>
            <p:cNvPr id="8" name="TextBox 7">
              <a:extLst>
                <a:ext uri="{FF2B5EF4-FFF2-40B4-BE49-F238E27FC236}">
                  <a16:creationId xmlns:a16="http://schemas.microsoft.com/office/drawing/2014/main" id="{9488ACD9-7C79-EB37-E5DD-51F1EB8CABEA}"/>
                </a:ext>
              </a:extLst>
            </p:cNvPr>
            <p:cNvSpPr txBox="1"/>
            <p:nvPr/>
          </p:nvSpPr>
          <p:spPr>
            <a:xfrm>
              <a:off x="4769916" y="2486086"/>
              <a:ext cx="558181" cy="400110"/>
            </a:xfrm>
            <a:prstGeom prst="rect">
              <a:avLst/>
            </a:prstGeom>
            <a:noFill/>
          </p:spPr>
          <p:txBody>
            <a:bodyPr wrap="square" rtlCol="0">
              <a:spAutoFit/>
            </a:bodyPr>
            <a:lstStyle/>
            <a:p>
              <a:pPr algn="ctr"/>
              <a:r>
                <a:rPr lang="en-ZA" sz="1000" dirty="0">
                  <a:solidFill>
                    <a:srgbClr val="FF0000"/>
                  </a:solidFill>
                </a:rPr>
                <a:t>200</a:t>
              </a:r>
              <a:br>
                <a:rPr lang="en-ZA" sz="1000" dirty="0"/>
              </a:br>
              <a:r>
                <a:rPr lang="en-ZA" sz="1000" dirty="0"/>
                <a:t>(1529)</a:t>
              </a:r>
            </a:p>
          </p:txBody>
        </p:sp>
        <p:sp>
          <p:nvSpPr>
            <p:cNvPr id="9" name="TextBox 8">
              <a:extLst>
                <a:ext uri="{FF2B5EF4-FFF2-40B4-BE49-F238E27FC236}">
                  <a16:creationId xmlns:a16="http://schemas.microsoft.com/office/drawing/2014/main" id="{E71666A6-5880-BAB6-D08D-728B02EDDBB0}"/>
                </a:ext>
              </a:extLst>
            </p:cNvPr>
            <p:cNvSpPr txBox="1"/>
            <p:nvPr/>
          </p:nvSpPr>
          <p:spPr>
            <a:xfrm>
              <a:off x="5260744" y="1296771"/>
              <a:ext cx="520032" cy="400110"/>
            </a:xfrm>
            <a:prstGeom prst="rect">
              <a:avLst/>
            </a:prstGeom>
            <a:noFill/>
          </p:spPr>
          <p:txBody>
            <a:bodyPr wrap="square" rtlCol="0">
              <a:spAutoFit/>
            </a:bodyPr>
            <a:lstStyle/>
            <a:p>
              <a:pPr algn="ctr"/>
              <a:r>
                <a:rPr lang="en-ZA" sz="1000" dirty="0">
                  <a:solidFill>
                    <a:srgbClr val="FF0000"/>
                  </a:solidFill>
                </a:rPr>
                <a:t>39</a:t>
              </a:r>
              <a:br>
                <a:rPr lang="en-ZA" sz="1000" dirty="0"/>
              </a:br>
              <a:r>
                <a:rPr lang="en-ZA" sz="1000" dirty="0"/>
                <a:t>(396)</a:t>
              </a:r>
            </a:p>
          </p:txBody>
        </p:sp>
        <p:sp>
          <p:nvSpPr>
            <p:cNvPr id="10" name="TextBox 9">
              <a:extLst>
                <a:ext uri="{FF2B5EF4-FFF2-40B4-BE49-F238E27FC236}">
                  <a16:creationId xmlns:a16="http://schemas.microsoft.com/office/drawing/2014/main" id="{3D8E1BFA-CCE7-11DE-1F91-D17049722C4A}"/>
                </a:ext>
              </a:extLst>
            </p:cNvPr>
            <p:cNvSpPr txBox="1"/>
            <p:nvPr/>
          </p:nvSpPr>
          <p:spPr>
            <a:xfrm>
              <a:off x="6276221" y="1252080"/>
              <a:ext cx="520032" cy="400110"/>
            </a:xfrm>
            <a:prstGeom prst="rect">
              <a:avLst/>
            </a:prstGeom>
            <a:noFill/>
          </p:spPr>
          <p:txBody>
            <a:bodyPr wrap="square" rtlCol="0">
              <a:spAutoFit/>
            </a:bodyPr>
            <a:lstStyle/>
            <a:p>
              <a:pPr algn="ctr"/>
              <a:r>
                <a:rPr lang="en-ZA" sz="1000" dirty="0">
                  <a:solidFill>
                    <a:srgbClr val="FF0000"/>
                  </a:solidFill>
                </a:rPr>
                <a:t>93</a:t>
              </a:r>
              <a:br>
                <a:rPr lang="en-ZA" sz="1000" dirty="0"/>
              </a:br>
              <a:r>
                <a:rPr lang="en-ZA" sz="1000" dirty="0"/>
                <a:t>(463)</a:t>
              </a:r>
            </a:p>
          </p:txBody>
        </p:sp>
        <p:sp>
          <p:nvSpPr>
            <p:cNvPr id="11" name="TextBox 10">
              <a:extLst>
                <a:ext uri="{FF2B5EF4-FFF2-40B4-BE49-F238E27FC236}">
                  <a16:creationId xmlns:a16="http://schemas.microsoft.com/office/drawing/2014/main" id="{4C95EA54-A72F-C600-B9A1-C74038A9AB2E}"/>
                </a:ext>
              </a:extLst>
            </p:cNvPr>
            <p:cNvSpPr txBox="1"/>
            <p:nvPr/>
          </p:nvSpPr>
          <p:spPr>
            <a:xfrm>
              <a:off x="5810838" y="2269605"/>
              <a:ext cx="461653" cy="400110"/>
            </a:xfrm>
            <a:prstGeom prst="rect">
              <a:avLst/>
            </a:prstGeom>
            <a:noFill/>
          </p:spPr>
          <p:txBody>
            <a:bodyPr wrap="square" rtlCol="0">
              <a:spAutoFit/>
            </a:bodyPr>
            <a:lstStyle/>
            <a:p>
              <a:pPr algn="ctr"/>
              <a:r>
                <a:rPr lang="en-ZA" sz="1000" dirty="0">
                  <a:solidFill>
                    <a:srgbClr val="FF0000"/>
                  </a:solidFill>
                </a:rPr>
                <a:t>37</a:t>
              </a:r>
              <a:br>
                <a:rPr lang="en-ZA" sz="1000" dirty="0"/>
              </a:br>
              <a:r>
                <a:rPr lang="en-ZA" sz="1000" dirty="0"/>
                <a:t>(502)</a:t>
              </a:r>
            </a:p>
          </p:txBody>
        </p:sp>
        <p:sp>
          <p:nvSpPr>
            <p:cNvPr id="12" name="TextBox 11">
              <a:extLst>
                <a:ext uri="{FF2B5EF4-FFF2-40B4-BE49-F238E27FC236}">
                  <a16:creationId xmlns:a16="http://schemas.microsoft.com/office/drawing/2014/main" id="{C2777FAA-37AA-1CCC-95A5-27D74A68BFB3}"/>
                </a:ext>
              </a:extLst>
            </p:cNvPr>
            <p:cNvSpPr txBox="1"/>
            <p:nvPr/>
          </p:nvSpPr>
          <p:spPr>
            <a:xfrm>
              <a:off x="5720417" y="1595776"/>
              <a:ext cx="562192" cy="400110"/>
            </a:xfrm>
            <a:prstGeom prst="rect">
              <a:avLst/>
            </a:prstGeom>
            <a:noFill/>
          </p:spPr>
          <p:txBody>
            <a:bodyPr wrap="square" rtlCol="0">
              <a:spAutoFit/>
            </a:bodyPr>
            <a:lstStyle/>
            <a:p>
              <a:pPr algn="ctr"/>
              <a:r>
                <a:rPr lang="en-ZA" sz="1000" b="1" dirty="0">
                  <a:solidFill>
                    <a:srgbClr val="FF0000"/>
                  </a:solidFill>
                </a:rPr>
                <a:t>2124</a:t>
              </a:r>
              <a:br>
                <a:rPr lang="en-ZA" sz="1000" b="1" dirty="0"/>
              </a:br>
              <a:r>
                <a:rPr lang="en-ZA" sz="1000" b="1" dirty="0"/>
                <a:t>(2948)</a:t>
              </a:r>
            </a:p>
          </p:txBody>
        </p:sp>
        <p:sp>
          <p:nvSpPr>
            <p:cNvPr id="29" name="TextBox 28">
              <a:extLst>
                <a:ext uri="{FF2B5EF4-FFF2-40B4-BE49-F238E27FC236}">
                  <a16:creationId xmlns:a16="http://schemas.microsoft.com/office/drawing/2014/main" id="{CB5FBEB5-3AFB-AE52-3521-863FAB3948EA}"/>
                </a:ext>
              </a:extLst>
            </p:cNvPr>
            <p:cNvSpPr txBox="1"/>
            <p:nvPr/>
          </p:nvSpPr>
          <p:spPr>
            <a:xfrm>
              <a:off x="4157891" y="73150"/>
              <a:ext cx="324128" cy="369332"/>
            </a:xfrm>
            <a:prstGeom prst="rect">
              <a:avLst/>
            </a:prstGeom>
            <a:noFill/>
          </p:spPr>
          <p:txBody>
            <a:bodyPr wrap="none" rtlCol="0">
              <a:spAutoFit/>
            </a:bodyPr>
            <a:lstStyle/>
            <a:p>
              <a:r>
                <a:rPr lang="en-ZA" b="1" dirty="0"/>
                <a:t>A</a:t>
              </a:r>
            </a:p>
          </p:txBody>
        </p:sp>
        <p:sp>
          <p:nvSpPr>
            <p:cNvPr id="31" name="TextBox 30">
              <a:extLst>
                <a:ext uri="{FF2B5EF4-FFF2-40B4-BE49-F238E27FC236}">
                  <a16:creationId xmlns:a16="http://schemas.microsoft.com/office/drawing/2014/main" id="{2ED41CDB-E546-94F4-AD00-6EFB86A3B631}"/>
                </a:ext>
              </a:extLst>
            </p:cNvPr>
            <p:cNvSpPr txBox="1"/>
            <p:nvPr/>
          </p:nvSpPr>
          <p:spPr>
            <a:xfrm>
              <a:off x="4175525" y="3249704"/>
              <a:ext cx="306494" cy="369332"/>
            </a:xfrm>
            <a:prstGeom prst="rect">
              <a:avLst/>
            </a:prstGeom>
            <a:noFill/>
          </p:spPr>
          <p:txBody>
            <a:bodyPr wrap="none" rtlCol="0">
              <a:spAutoFit/>
            </a:bodyPr>
            <a:lstStyle/>
            <a:p>
              <a:r>
                <a:rPr lang="en-ZA" b="1" dirty="0"/>
                <a:t>C</a:t>
              </a:r>
            </a:p>
          </p:txBody>
        </p:sp>
      </p:grpSp>
      <p:sp>
        <p:nvSpPr>
          <p:cNvPr id="33" name="TextBox 32">
            <a:extLst>
              <a:ext uri="{FF2B5EF4-FFF2-40B4-BE49-F238E27FC236}">
                <a16:creationId xmlns:a16="http://schemas.microsoft.com/office/drawing/2014/main" id="{FFAAC9B4-4C84-49FB-A0F3-43D8CB6F2284}"/>
              </a:ext>
            </a:extLst>
          </p:cNvPr>
          <p:cNvSpPr txBox="1"/>
          <p:nvPr/>
        </p:nvSpPr>
        <p:spPr>
          <a:xfrm>
            <a:off x="5573327" y="4256464"/>
            <a:ext cx="6544531" cy="2351349"/>
          </a:xfrm>
          <a:prstGeom prst="rect">
            <a:avLst/>
          </a:prstGeom>
          <a:noFill/>
        </p:spPr>
        <p:txBody>
          <a:bodyPr wrap="square">
            <a:spAutoFit/>
          </a:bodyPr>
          <a:lstStyle/>
          <a:p>
            <a:pPr algn="just">
              <a:lnSpc>
                <a:spcPct val="150000"/>
              </a:lnSpc>
              <a:spcAft>
                <a:spcPts val="800"/>
              </a:spcAft>
            </a:pPr>
            <a:r>
              <a:rPr lang="en-ZA" sz="1100" b="1" kern="100" dirty="0">
                <a:effectLst/>
                <a:latin typeface="+mj-lt"/>
                <a:ea typeface="Calibri" panose="020F0502020204030204" pitchFamily="34" charset="0"/>
                <a:cs typeface="Arial" panose="020B0604020202020204" pitchFamily="34" charset="0"/>
              </a:rPr>
              <a:t>Figure S2: Protein conservation and function in the species </a:t>
            </a:r>
            <a:r>
              <a:rPr lang="en-ZA" sz="1100" b="1" i="1" kern="100" dirty="0">
                <a:effectLst/>
                <a:latin typeface="+mj-lt"/>
                <a:ea typeface="Calibri" panose="020F0502020204030204" pitchFamily="34" charset="0"/>
                <a:cs typeface="Arial" panose="020B0604020202020204" pitchFamily="34" charset="0"/>
              </a:rPr>
              <a:t>P. thermoglucosidasius, P. </a:t>
            </a:r>
            <a:r>
              <a:rPr lang="en-ZA" sz="1100" b="1" i="1" kern="100" dirty="0" err="1">
                <a:effectLst/>
                <a:latin typeface="+mj-lt"/>
                <a:ea typeface="Calibri" panose="020F0502020204030204" pitchFamily="34" charset="0"/>
                <a:cs typeface="Arial" panose="020B0604020202020204" pitchFamily="34" charset="0"/>
              </a:rPr>
              <a:t>toebii</a:t>
            </a:r>
            <a:r>
              <a:rPr lang="en-ZA" sz="1100" b="1" i="1" kern="100" dirty="0">
                <a:effectLst/>
                <a:latin typeface="+mj-lt"/>
                <a:ea typeface="Calibri" panose="020F0502020204030204" pitchFamily="34" charset="0"/>
                <a:cs typeface="Arial" panose="020B0604020202020204" pitchFamily="34" charset="0"/>
              </a:rPr>
              <a:t> </a:t>
            </a:r>
            <a:r>
              <a:rPr lang="en-ZA" sz="1100" b="1" kern="100" dirty="0">
                <a:effectLst/>
                <a:latin typeface="+mj-lt"/>
                <a:ea typeface="Calibri" panose="020F0502020204030204" pitchFamily="34" charset="0"/>
                <a:cs typeface="Arial" panose="020B0604020202020204" pitchFamily="34" charset="0"/>
              </a:rPr>
              <a:t>and </a:t>
            </a:r>
            <a:r>
              <a:rPr lang="en-ZA" sz="1100" b="1" i="1" kern="100" dirty="0">
                <a:effectLst/>
                <a:latin typeface="+mj-lt"/>
                <a:ea typeface="Calibri" panose="020F0502020204030204" pitchFamily="34" charset="0"/>
                <a:cs typeface="Arial" panose="020B0604020202020204" pitchFamily="34" charset="0"/>
              </a:rPr>
              <a:t>S. </a:t>
            </a:r>
            <a:r>
              <a:rPr lang="en-ZA" sz="1100" b="1" i="1" kern="100" dirty="0" err="1">
                <a:effectLst/>
                <a:latin typeface="+mj-lt"/>
                <a:ea typeface="Calibri" panose="020F0502020204030204" pitchFamily="34" charset="0"/>
                <a:cs typeface="Arial" panose="020B0604020202020204" pitchFamily="34" charset="0"/>
              </a:rPr>
              <a:t>caldoxylosilyticus</a:t>
            </a:r>
            <a:r>
              <a:rPr lang="en-ZA" sz="1100" b="1" i="1" kern="100" dirty="0">
                <a:effectLst/>
                <a:latin typeface="+mj-lt"/>
                <a:ea typeface="Calibri" panose="020F0502020204030204" pitchFamily="34" charset="0"/>
                <a:cs typeface="Arial" panose="020B0604020202020204" pitchFamily="34" charset="0"/>
              </a:rPr>
              <a:t>.</a:t>
            </a:r>
            <a:r>
              <a:rPr lang="en-ZA" sz="1100" b="1" kern="100" dirty="0">
                <a:effectLst/>
                <a:latin typeface="+mj-lt"/>
                <a:ea typeface="Calibri" panose="020F0502020204030204" pitchFamily="34" charset="0"/>
                <a:cs typeface="Arial" panose="020B0604020202020204" pitchFamily="34" charset="0"/>
              </a:rPr>
              <a:t> </a:t>
            </a:r>
            <a:r>
              <a:rPr lang="en-ZA" sz="1100" kern="100" dirty="0">
                <a:effectLst/>
                <a:latin typeface="+mj-lt"/>
                <a:ea typeface="Calibri" panose="020F0502020204030204" pitchFamily="34" charset="0"/>
                <a:cs typeface="Arial" panose="020B0604020202020204" pitchFamily="34" charset="0"/>
              </a:rPr>
              <a:t>A) Proportion of conserved and genus-specific </a:t>
            </a:r>
            <a:r>
              <a:rPr lang="en-ZA" sz="1100" kern="100" dirty="0" err="1">
                <a:effectLst/>
                <a:latin typeface="+mj-lt"/>
                <a:ea typeface="Calibri" panose="020F0502020204030204" pitchFamily="34" charset="0"/>
                <a:cs typeface="Arial" panose="020B0604020202020204" pitchFamily="34" charset="0"/>
              </a:rPr>
              <a:t>orthogroups</a:t>
            </a:r>
            <a:r>
              <a:rPr lang="en-ZA" sz="1100" kern="100" dirty="0">
                <a:effectLst/>
                <a:latin typeface="+mj-lt"/>
                <a:ea typeface="Calibri" panose="020F0502020204030204" pitchFamily="34" charset="0"/>
                <a:cs typeface="Arial" panose="020B0604020202020204" pitchFamily="34" charset="0"/>
              </a:rPr>
              <a:t> for the two genera. Numbers in red indicate those proteins conserved in all taxa within each dataset, while those in brackets reflect those that are present in some, but not necessarily all taxa within each genus or the combination of the genera. B) Conserved Orthologous Group supra-functional categories for the proteins conserved among all taxa in all species, those specific to each species and those shared between 2/3 species. C) Functional categorisation of the pan-genome elements on the basis of the COG functional categories. The graphs represent the relative proportions as calculated for those proteins categorized for a COG function (with the exception of category S: function unknown). The number of proteins assigned to COG functional categories are shown in brackets above each bar.</a:t>
            </a:r>
          </a:p>
        </p:txBody>
      </p:sp>
    </p:spTree>
    <p:extLst>
      <p:ext uri="{BB962C8B-B14F-4D97-AF65-F5344CB8AC3E}">
        <p14:creationId xmlns:p14="http://schemas.microsoft.com/office/powerpoint/2010/main" val="14816504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TotalTime>
  <Words>346</Words>
  <Application>Microsoft Office PowerPoint</Application>
  <PresentationFormat>Widescreen</PresentationFormat>
  <Paragraphs>43</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ieter De Maayer</dc:creator>
  <cp:lastModifiedBy>Pieter De Maayer</cp:lastModifiedBy>
  <cp:revision>2</cp:revision>
  <dcterms:created xsi:type="dcterms:W3CDTF">2024-02-13T09:06:27Z</dcterms:created>
  <dcterms:modified xsi:type="dcterms:W3CDTF">2024-07-17T10:10:01Z</dcterms:modified>
</cp:coreProperties>
</file>